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9906000" cy="6858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-672" y="-84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12517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5008"/>
            </a:lvl1pPr>
            <a:lvl2pPr marL="953853" indent="0" algn="ctr">
              <a:buNone/>
              <a:defRPr sz="4173"/>
            </a:lvl2pPr>
            <a:lvl3pPr marL="1907704" indent="0" algn="ctr">
              <a:buNone/>
              <a:defRPr sz="3755"/>
            </a:lvl3pPr>
            <a:lvl4pPr marL="2861557" indent="0" algn="ctr">
              <a:buNone/>
              <a:defRPr sz="3338"/>
            </a:lvl4pPr>
            <a:lvl5pPr marL="3815410" indent="0" algn="ctr">
              <a:buNone/>
              <a:defRPr sz="3338"/>
            </a:lvl5pPr>
            <a:lvl6pPr marL="4769261" indent="0" algn="ctr">
              <a:buNone/>
              <a:defRPr sz="3338"/>
            </a:lvl6pPr>
            <a:lvl7pPr marL="5723114" indent="0" algn="ctr">
              <a:buNone/>
              <a:defRPr sz="3338"/>
            </a:lvl7pPr>
            <a:lvl8pPr marL="6676967" indent="0" algn="ctr">
              <a:buNone/>
              <a:defRPr sz="3338"/>
            </a:lvl8pPr>
            <a:lvl9pPr marL="7630819" indent="0" algn="ctr">
              <a:buNone/>
              <a:defRPr sz="3338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30189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733564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4" y="365125"/>
            <a:ext cx="2135981" cy="581183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40" y="365125"/>
            <a:ext cx="6284119" cy="5811838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35282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2383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2"/>
            <a:ext cx="8543925" cy="2852737"/>
          </a:xfrm>
        </p:spPr>
        <p:txBody>
          <a:bodyPr anchor="b"/>
          <a:lstStyle>
            <a:lvl1pPr>
              <a:defRPr sz="12517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7"/>
            <a:ext cx="8543925" cy="1500187"/>
          </a:xfrm>
        </p:spPr>
        <p:txBody>
          <a:bodyPr/>
          <a:lstStyle>
            <a:lvl1pPr marL="0" indent="0">
              <a:buNone/>
              <a:defRPr sz="5008">
                <a:solidFill>
                  <a:schemeClr val="tx1"/>
                </a:solidFill>
              </a:defRPr>
            </a:lvl1pPr>
            <a:lvl2pPr marL="953853" indent="0">
              <a:buNone/>
              <a:defRPr sz="4173">
                <a:solidFill>
                  <a:schemeClr val="tx1">
                    <a:tint val="75000"/>
                  </a:schemeClr>
                </a:solidFill>
              </a:defRPr>
            </a:lvl2pPr>
            <a:lvl3pPr marL="1907704" indent="0">
              <a:buNone/>
              <a:defRPr sz="3755">
                <a:solidFill>
                  <a:schemeClr val="tx1">
                    <a:tint val="75000"/>
                  </a:schemeClr>
                </a:solidFill>
              </a:defRPr>
            </a:lvl3pPr>
            <a:lvl4pPr marL="2861557" indent="0">
              <a:buNone/>
              <a:defRPr sz="3338">
                <a:solidFill>
                  <a:schemeClr val="tx1">
                    <a:tint val="75000"/>
                  </a:schemeClr>
                </a:solidFill>
              </a:defRPr>
            </a:lvl4pPr>
            <a:lvl5pPr marL="3815410" indent="0">
              <a:buNone/>
              <a:defRPr sz="3338">
                <a:solidFill>
                  <a:schemeClr val="tx1">
                    <a:tint val="75000"/>
                  </a:schemeClr>
                </a:solidFill>
              </a:defRPr>
            </a:lvl5pPr>
            <a:lvl6pPr marL="4769261" indent="0">
              <a:buNone/>
              <a:defRPr sz="3338">
                <a:solidFill>
                  <a:schemeClr val="tx1">
                    <a:tint val="75000"/>
                  </a:schemeClr>
                </a:solidFill>
              </a:defRPr>
            </a:lvl6pPr>
            <a:lvl7pPr marL="5723114" indent="0">
              <a:buNone/>
              <a:defRPr sz="3338">
                <a:solidFill>
                  <a:schemeClr val="tx1">
                    <a:tint val="75000"/>
                  </a:schemeClr>
                </a:solidFill>
              </a:defRPr>
            </a:lvl7pPr>
            <a:lvl8pPr marL="6676967" indent="0">
              <a:buNone/>
              <a:defRPr sz="3338">
                <a:solidFill>
                  <a:schemeClr val="tx1">
                    <a:tint val="75000"/>
                  </a:schemeClr>
                </a:solidFill>
              </a:defRPr>
            </a:lvl8pPr>
            <a:lvl9pPr marL="7630819" indent="0">
              <a:buNone/>
              <a:defRPr sz="333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6820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096136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365129"/>
            <a:ext cx="8543925" cy="132556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4"/>
            <a:ext cx="4190702" cy="823912"/>
          </a:xfrm>
        </p:spPr>
        <p:txBody>
          <a:bodyPr anchor="b"/>
          <a:lstStyle>
            <a:lvl1pPr marL="0" indent="0">
              <a:buNone/>
              <a:defRPr sz="5008" b="1"/>
            </a:lvl1pPr>
            <a:lvl2pPr marL="953853" indent="0">
              <a:buNone/>
              <a:defRPr sz="4173" b="1"/>
            </a:lvl2pPr>
            <a:lvl3pPr marL="1907704" indent="0">
              <a:buNone/>
              <a:defRPr sz="3755" b="1"/>
            </a:lvl3pPr>
            <a:lvl4pPr marL="2861557" indent="0">
              <a:buNone/>
              <a:defRPr sz="3338" b="1"/>
            </a:lvl4pPr>
            <a:lvl5pPr marL="3815410" indent="0">
              <a:buNone/>
              <a:defRPr sz="3338" b="1"/>
            </a:lvl5pPr>
            <a:lvl6pPr marL="4769261" indent="0">
              <a:buNone/>
              <a:defRPr sz="3338" b="1"/>
            </a:lvl6pPr>
            <a:lvl7pPr marL="5723114" indent="0">
              <a:buNone/>
              <a:defRPr sz="3338" b="1"/>
            </a:lvl7pPr>
            <a:lvl8pPr marL="6676967" indent="0">
              <a:buNone/>
              <a:defRPr sz="3338" b="1"/>
            </a:lvl8pPr>
            <a:lvl9pPr marL="7630819" indent="0">
              <a:buNone/>
              <a:defRPr sz="3338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6"/>
            <a:ext cx="4190702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5" y="1681164"/>
            <a:ext cx="4211340" cy="823912"/>
          </a:xfrm>
        </p:spPr>
        <p:txBody>
          <a:bodyPr anchor="b"/>
          <a:lstStyle>
            <a:lvl1pPr marL="0" indent="0">
              <a:buNone/>
              <a:defRPr sz="5008" b="1"/>
            </a:lvl1pPr>
            <a:lvl2pPr marL="953853" indent="0">
              <a:buNone/>
              <a:defRPr sz="4173" b="1"/>
            </a:lvl2pPr>
            <a:lvl3pPr marL="1907704" indent="0">
              <a:buNone/>
              <a:defRPr sz="3755" b="1"/>
            </a:lvl3pPr>
            <a:lvl4pPr marL="2861557" indent="0">
              <a:buNone/>
              <a:defRPr sz="3338" b="1"/>
            </a:lvl4pPr>
            <a:lvl5pPr marL="3815410" indent="0">
              <a:buNone/>
              <a:defRPr sz="3338" b="1"/>
            </a:lvl5pPr>
            <a:lvl6pPr marL="4769261" indent="0">
              <a:buNone/>
              <a:defRPr sz="3338" b="1"/>
            </a:lvl6pPr>
            <a:lvl7pPr marL="5723114" indent="0">
              <a:buNone/>
              <a:defRPr sz="3338" b="1"/>
            </a:lvl7pPr>
            <a:lvl8pPr marL="6676967" indent="0">
              <a:buNone/>
              <a:defRPr sz="3338" b="1"/>
            </a:lvl8pPr>
            <a:lvl9pPr marL="7630819" indent="0">
              <a:buNone/>
              <a:defRPr sz="3338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5" y="2505076"/>
            <a:ext cx="4211340" cy="3684588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111218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97876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584788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6676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1" y="987429"/>
            <a:ext cx="5014913" cy="4873625"/>
          </a:xfrm>
        </p:spPr>
        <p:txBody>
          <a:bodyPr/>
          <a:lstStyle>
            <a:lvl1pPr>
              <a:defRPr sz="6676"/>
            </a:lvl1pPr>
            <a:lvl2pPr>
              <a:defRPr sz="5841"/>
            </a:lvl2pPr>
            <a:lvl3pPr>
              <a:defRPr sz="5008"/>
            </a:lvl3pPr>
            <a:lvl4pPr>
              <a:defRPr sz="4173"/>
            </a:lvl4pPr>
            <a:lvl5pPr>
              <a:defRPr sz="4173"/>
            </a:lvl5pPr>
            <a:lvl6pPr>
              <a:defRPr sz="4173"/>
            </a:lvl6pPr>
            <a:lvl7pPr>
              <a:defRPr sz="4173"/>
            </a:lvl7pPr>
            <a:lvl8pPr>
              <a:defRPr sz="4173"/>
            </a:lvl8pPr>
            <a:lvl9pPr>
              <a:defRPr sz="4173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3338"/>
            </a:lvl1pPr>
            <a:lvl2pPr marL="953853" indent="0">
              <a:buNone/>
              <a:defRPr sz="2921"/>
            </a:lvl2pPr>
            <a:lvl3pPr marL="1907704" indent="0">
              <a:buNone/>
              <a:defRPr sz="2503"/>
            </a:lvl3pPr>
            <a:lvl4pPr marL="2861557" indent="0">
              <a:buNone/>
              <a:defRPr sz="2086"/>
            </a:lvl4pPr>
            <a:lvl5pPr marL="3815410" indent="0">
              <a:buNone/>
              <a:defRPr sz="2086"/>
            </a:lvl5pPr>
            <a:lvl6pPr marL="4769261" indent="0">
              <a:buNone/>
              <a:defRPr sz="2086"/>
            </a:lvl6pPr>
            <a:lvl7pPr marL="5723114" indent="0">
              <a:buNone/>
              <a:defRPr sz="2086"/>
            </a:lvl7pPr>
            <a:lvl8pPr marL="6676967" indent="0">
              <a:buNone/>
              <a:defRPr sz="2086"/>
            </a:lvl8pPr>
            <a:lvl9pPr marL="7630819" indent="0">
              <a:buNone/>
              <a:defRPr sz="2086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902475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6676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1" y="987429"/>
            <a:ext cx="5014913" cy="4873625"/>
          </a:xfrm>
        </p:spPr>
        <p:txBody>
          <a:bodyPr anchor="t"/>
          <a:lstStyle>
            <a:lvl1pPr marL="0" indent="0">
              <a:buNone/>
              <a:defRPr sz="6676"/>
            </a:lvl1pPr>
            <a:lvl2pPr marL="953853" indent="0">
              <a:buNone/>
              <a:defRPr sz="5841"/>
            </a:lvl2pPr>
            <a:lvl3pPr marL="1907704" indent="0">
              <a:buNone/>
              <a:defRPr sz="5008"/>
            </a:lvl3pPr>
            <a:lvl4pPr marL="2861557" indent="0">
              <a:buNone/>
              <a:defRPr sz="4173"/>
            </a:lvl4pPr>
            <a:lvl5pPr marL="3815410" indent="0">
              <a:buNone/>
              <a:defRPr sz="4173"/>
            </a:lvl5pPr>
            <a:lvl6pPr marL="4769261" indent="0">
              <a:buNone/>
              <a:defRPr sz="4173"/>
            </a:lvl6pPr>
            <a:lvl7pPr marL="5723114" indent="0">
              <a:buNone/>
              <a:defRPr sz="4173"/>
            </a:lvl7pPr>
            <a:lvl8pPr marL="6676967" indent="0">
              <a:buNone/>
              <a:defRPr sz="4173"/>
            </a:lvl8pPr>
            <a:lvl9pPr marL="7630819" indent="0">
              <a:buNone/>
              <a:defRPr sz="4173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3338"/>
            </a:lvl1pPr>
            <a:lvl2pPr marL="953853" indent="0">
              <a:buNone/>
              <a:defRPr sz="2921"/>
            </a:lvl2pPr>
            <a:lvl3pPr marL="1907704" indent="0">
              <a:buNone/>
              <a:defRPr sz="2503"/>
            </a:lvl3pPr>
            <a:lvl4pPr marL="2861557" indent="0">
              <a:buNone/>
              <a:defRPr sz="2086"/>
            </a:lvl4pPr>
            <a:lvl5pPr marL="3815410" indent="0">
              <a:buNone/>
              <a:defRPr sz="2086"/>
            </a:lvl5pPr>
            <a:lvl6pPr marL="4769261" indent="0">
              <a:buNone/>
              <a:defRPr sz="2086"/>
            </a:lvl6pPr>
            <a:lvl7pPr marL="5723114" indent="0">
              <a:buNone/>
              <a:defRPr sz="2086"/>
            </a:lvl7pPr>
            <a:lvl8pPr marL="6676967" indent="0">
              <a:buNone/>
              <a:defRPr sz="2086"/>
            </a:lvl8pPr>
            <a:lvl9pPr marL="7630819" indent="0">
              <a:buNone/>
              <a:defRPr sz="2086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177668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9" y="365129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4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5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D5F7A9-3AEA-47DC-899A-CBA8E91BC2EE}" type="datetimeFigureOut">
              <a:rPr lang="fr-FR" smtClean="0"/>
              <a:t>28/02/2018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4" y="6356354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5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4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5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C0AEC6-411A-4B4C-A13D-0FA7A2759312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50906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907704" rtl="0" eaLnBrk="1" latinLnBrk="0" hangingPunct="1">
        <a:lnSpc>
          <a:spcPct val="90000"/>
        </a:lnSpc>
        <a:spcBef>
          <a:spcPct val="0"/>
        </a:spcBef>
        <a:buNone/>
        <a:defRPr sz="917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76926" indent="-476926" algn="l" defTabSz="1907704" rtl="0" eaLnBrk="1" latinLnBrk="0" hangingPunct="1">
        <a:lnSpc>
          <a:spcPct val="90000"/>
        </a:lnSpc>
        <a:spcBef>
          <a:spcPts val="2086"/>
        </a:spcBef>
        <a:buFont typeface="Arial" panose="020B0604020202020204" pitchFamily="34" charset="0"/>
        <a:buChar char="•"/>
        <a:defRPr sz="5841" kern="1200">
          <a:solidFill>
            <a:schemeClr val="tx1"/>
          </a:solidFill>
          <a:latin typeface="+mn-lt"/>
          <a:ea typeface="+mn-ea"/>
          <a:cs typeface="+mn-cs"/>
        </a:defRPr>
      </a:lvl1pPr>
      <a:lvl2pPr marL="1430779" indent="-476926" algn="l" defTabSz="1907704" rtl="0" eaLnBrk="1" latinLnBrk="0" hangingPunct="1">
        <a:lnSpc>
          <a:spcPct val="90000"/>
        </a:lnSpc>
        <a:spcBef>
          <a:spcPts val="1043"/>
        </a:spcBef>
        <a:buFont typeface="Arial" panose="020B0604020202020204" pitchFamily="34" charset="0"/>
        <a:buChar char="•"/>
        <a:defRPr sz="5008" kern="1200">
          <a:solidFill>
            <a:schemeClr val="tx1"/>
          </a:solidFill>
          <a:latin typeface="+mn-lt"/>
          <a:ea typeface="+mn-ea"/>
          <a:cs typeface="+mn-cs"/>
        </a:defRPr>
      </a:lvl2pPr>
      <a:lvl3pPr marL="2384631" indent="-476926" algn="l" defTabSz="1907704" rtl="0" eaLnBrk="1" latinLnBrk="0" hangingPunct="1">
        <a:lnSpc>
          <a:spcPct val="90000"/>
        </a:lnSpc>
        <a:spcBef>
          <a:spcPts val="1043"/>
        </a:spcBef>
        <a:buFont typeface="Arial" panose="020B0604020202020204" pitchFamily="34" charset="0"/>
        <a:buChar char="•"/>
        <a:defRPr sz="4173" kern="1200">
          <a:solidFill>
            <a:schemeClr val="tx1"/>
          </a:solidFill>
          <a:latin typeface="+mn-lt"/>
          <a:ea typeface="+mn-ea"/>
          <a:cs typeface="+mn-cs"/>
        </a:defRPr>
      </a:lvl3pPr>
      <a:lvl4pPr marL="3338484" indent="-476926" algn="l" defTabSz="1907704" rtl="0" eaLnBrk="1" latinLnBrk="0" hangingPunct="1">
        <a:lnSpc>
          <a:spcPct val="90000"/>
        </a:lnSpc>
        <a:spcBef>
          <a:spcPts val="1043"/>
        </a:spcBef>
        <a:buFont typeface="Arial" panose="020B0604020202020204" pitchFamily="34" charset="0"/>
        <a:buChar char="•"/>
        <a:defRPr sz="3755" kern="1200">
          <a:solidFill>
            <a:schemeClr val="tx1"/>
          </a:solidFill>
          <a:latin typeface="+mn-lt"/>
          <a:ea typeface="+mn-ea"/>
          <a:cs typeface="+mn-cs"/>
        </a:defRPr>
      </a:lvl4pPr>
      <a:lvl5pPr marL="4292336" indent="-476926" algn="l" defTabSz="1907704" rtl="0" eaLnBrk="1" latinLnBrk="0" hangingPunct="1">
        <a:lnSpc>
          <a:spcPct val="90000"/>
        </a:lnSpc>
        <a:spcBef>
          <a:spcPts val="1043"/>
        </a:spcBef>
        <a:buFont typeface="Arial" panose="020B0604020202020204" pitchFamily="34" charset="0"/>
        <a:buChar char="•"/>
        <a:defRPr sz="3755" kern="1200">
          <a:solidFill>
            <a:schemeClr val="tx1"/>
          </a:solidFill>
          <a:latin typeface="+mn-lt"/>
          <a:ea typeface="+mn-ea"/>
          <a:cs typeface="+mn-cs"/>
        </a:defRPr>
      </a:lvl5pPr>
      <a:lvl6pPr marL="5246188" indent="-476926" algn="l" defTabSz="1907704" rtl="0" eaLnBrk="1" latinLnBrk="0" hangingPunct="1">
        <a:lnSpc>
          <a:spcPct val="90000"/>
        </a:lnSpc>
        <a:spcBef>
          <a:spcPts val="1043"/>
        </a:spcBef>
        <a:buFont typeface="Arial" panose="020B0604020202020204" pitchFamily="34" charset="0"/>
        <a:buChar char="•"/>
        <a:defRPr sz="3755" kern="1200">
          <a:solidFill>
            <a:schemeClr val="tx1"/>
          </a:solidFill>
          <a:latin typeface="+mn-lt"/>
          <a:ea typeface="+mn-ea"/>
          <a:cs typeface="+mn-cs"/>
        </a:defRPr>
      </a:lvl6pPr>
      <a:lvl7pPr marL="6200041" indent="-476926" algn="l" defTabSz="1907704" rtl="0" eaLnBrk="1" latinLnBrk="0" hangingPunct="1">
        <a:lnSpc>
          <a:spcPct val="90000"/>
        </a:lnSpc>
        <a:spcBef>
          <a:spcPts val="1043"/>
        </a:spcBef>
        <a:buFont typeface="Arial" panose="020B0604020202020204" pitchFamily="34" charset="0"/>
        <a:buChar char="•"/>
        <a:defRPr sz="3755" kern="1200">
          <a:solidFill>
            <a:schemeClr val="tx1"/>
          </a:solidFill>
          <a:latin typeface="+mn-lt"/>
          <a:ea typeface="+mn-ea"/>
          <a:cs typeface="+mn-cs"/>
        </a:defRPr>
      </a:lvl7pPr>
      <a:lvl8pPr marL="7153894" indent="-476926" algn="l" defTabSz="1907704" rtl="0" eaLnBrk="1" latinLnBrk="0" hangingPunct="1">
        <a:lnSpc>
          <a:spcPct val="90000"/>
        </a:lnSpc>
        <a:spcBef>
          <a:spcPts val="1043"/>
        </a:spcBef>
        <a:buFont typeface="Arial" panose="020B0604020202020204" pitchFamily="34" charset="0"/>
        <a:buChar char="•"/>
        <a:defRPr sz="3755" kern="1200">
          <a:solidFill>
            <a:schemeClr val="tx1"/>
          </a:solidFill>
          <a:latin typeface="+mn-lt"/>
          <a:ea typeface="+mn-ea"/>
          <a:cs typeface="+mn-cs"/>
        </a:defRPr>
      </a:lvl8pPr>
      <a:lvl9pPr marL="8107745" indent="-476926" algn="l" defTabSz="1907704" rtl="0" eaLnBrk="1" latinLnBrk="0" hangingPunct="1">
        <a:lnSpc>
          <a:spcPct val="90000"/>
        </a:lnSpc>
        <a:spcBef>
          <a:spcPts val="1043"/>
        </a:spcBef>
        <a:buFont typeface="Arial" panose="020B0604020202020204" pitchFamily="34" charset="0"/>
        <a:buChar char="•"/>
        <a:defRPr sz="375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907704" rtl="0" eaLnBrk="1" latinLnBrk="0" hangingPunct="1">
        <a:defRPr sz="3755" kern="1200">
          <a:solidFill>
            <a:schemeClr val="tx1"/>
          </a:solidFill>
          <a:latin typeface="+mn-lt"/>
          <a:ea typeface="+mn-ea"/>
          <a:cs typeface="+mn-cs"/>
        </a:defRPr>
      </a:lvl1pPr>
      <a:lvl2pPr marL="953853" algn="l" defTabSz="1907704" rtl="0" eaLnBrk="1" latinLnBrk="0" hangingPunct="1">
        <a:defRPr sz="3755" kern="1200">
          <a:solidFill>
            <a:schemeClr val="tx1"/>
          </a:solidFill>
          <a:latin typeface="+mn-lt"/>
          <a:ea typeface="+mn-ea"/>
          <a:cs typeface="+mn-cs"/>
        </a:defRPr>
      </a:lvl2pPr>
      <a:lvl3pPr marL="1907704" algn="l" defTabSz="1907704" rtl="0" eaLnBrk="1" latinLnBrk="0" hangingPunct="1">
        <a:defRPr sz="3755" kern="1200">
          <a:solidFill>
            <a:schemeClr val="tx1"/>
          </a:solidFill>
          <a:latin typeface="+mn-lt"/>
          <a:ea typeface="+mn-ea"/>
          <a:cs typeface="+mn-cs"/>
        </a:defRPr>
      </a:lvl3pPr>
      <a:lvl4pPr marL="2861557" algn="l" defTabSz="1907704" rtl="0" eaLnBrk="1" latinLnBrk="0" hangingPunct="1">
        <a:defRPr sz="3755" kern="1200">
          <a:solidFill>
            <a:schemeClr val="tx1"/>
          </a:solidFill>
          <a:latin typeface="+mn-lt"/>
          <a:ea typeface="+mn-ea"/>
          <a:cs typeface="+mn-cs"/>
        </a:defRPr>
      </a:lvl4pPr>
      <a:lvl5pPr marL="3815410" algn="l" defTabSz="1907704" rtl="0" eaLnBrk="1" latinLnBrk="0" hangingPunct="1">
        <a:defRPr sz="3755" kern="1200">
          <a:solidFill>
            <a:schemeClr val="tx1"/>
          </a:solidFill>
          <a:latin typeface="+mn-lt"/>
          <a:ea typeface="+mn-ea"/>
          <a:cs typeface="+mn-cs"/>
        </a:defRPr>
      </a:lvl5pPr>
      <a:lvl6pPr marL="4769261" algn="l" defTabSz="1907704" rtl="0" eaLnBrk="1" latinLnBrk="0" hangingPunct="1">
        <a:defRPr sz="3755" kern="1200">
          <a:solidFill>
            <a:schemeClr val="tx1"/>
          </a:solidFill>
          <a:latin typeface="+mn-lt"/>
          <a:ea typeface="+mn-ea"/>
          <a:cs typeface="+mn-cs"/>
        </a:defRPr>
      </a:lvl6pPr>
      <a:lvl7pPr marL="5723114" algn="l" defTabSz="1907704" rtl="0" eaLnBrk="1" latinLnBrk="0" hangingPunct="1">
        <a:defRPr sz="3755" kern="1200">
          <a:solidFill>
            <a:schemeClr val="tx1"/>
          </a:solidFill>
          <a:latin typeface="+mn-lt"/>
          <a:ea typeface="+mn-ea"/>
          <a:cs typeface="+mn-cs"/>
        </a:defRPr>
      </a:lvl7pPr>
      <a:lvl8pPr marL="6676967" algn="l" defTabSz="1907704" rtl="0" eaLnBrk="1" latinLnBrk="0" hangingPunct="1">
        <a:defRPr sz="3755" kern="1200">
          <a:solidFill>
            <a:schemeClr val="tx1"/>
          </a:solidFill>
          <a:latin typeface="+mn-lt"/>
          <a:ea typeface="+mn-ea"/>
          <a:cs typeface="+mn-cs"/>
        </a:defRPr>
      </a:lvl8pPr>
      <a:lvl9pPr marL="7630819" algn="l" defTabSz="1907704" rtl="0" eaLnBrk="1" latinLnBrk="0" hangingPunct="1">
        <a:defRPr sz="375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Line 5"/>
          <p:cNvSpPr>
            <a:spLocks noChangeShapeType="1"/>
          </p:cNvSpPr>
          <p:nvPr/>
        </p:nvSpPr>
        <p:spPr bwMode="auto">
          <a:xfrm>
            <a:off x="4048126" y="6667500"/>
            <a:ext cx="712788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bevel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9" name="Rectangle 6"/>
          <p:cNvSpPr>
            <a:spLocks noChangeArrowheads="1"/>
          </p:cNvSpPr>
          <p:nvPr/>
        </p:nvSpPr>
        <p:spPr bwMode="auto">
          <a:xfrm>
            <a:off x="4338638" y="6753225"/>
            <a:ext cx="11541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0.4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" name="Freeform 7"/>
          <p:cNvSpPr>
            <a:spLocks/>
          </p:cNvSpPr>
          <p:nvPr/>
        </p:nvSpPr>
        <p:spPr bwMode="auto">
          <a:xfrm>
            <a:off x="7112001" y="5511800"/>
            <a:ext cx="1527175" cy="711200"/>
          </a:xfrm>
          <a:custGeom>
            <a:avLst/>
            <a:gdLst>
              <a:gd name="T0" fmla="*/ 0 w 5341"/>
              <a:gd name="T1" fmla="*/ 0 h 1865"/>
              <a:gd name="T2" fmla="*/ 0 w 5341"/>
              <a:gd name="T3" fmla="*/ 932 h 1865"/>
              <a:gd name="T4" fmla="*/ 0 w 5341"/>
              <a:gd name="T5" fmla="*/ 1865 h 1865"/>
              <a:gd name="T6" fmla="*/ 623 w 5341"/>
              <a:gd name="T7" fmla="*/ 1865 h 1865"/>
              <a:gd name="T8" fmla="*/ 623 w 5341"/>
              <a:gd name="T9" fmla="*/ 1399 h 1865"/>
              <a:gd name="T10" fmla="*/ 5341 w 5341"/>
              <a:gd name="T11" fmla="*/ 1399 h 1865"/>
              <a:gd name="T12" fmla="*/ 5341 w 5341"/>
              <a:gd name="T13" fmla="*/ 777 h 1865"/>
              <a:gd name="T14" fmla="*/ 2315 w 5341"/>
              <a:gd name="T15" fmla="*/ 777 h 1865"/>
              <a:gd name="T16" fmla="*/ 2315 w 5341"/>
              <a:gd name="T17" fmla="*/ 466 h 1865"/>
              <a:gd name="T18" fmla="*/ 1894 w 5341"/>
              <a:gd name="T19" fmla="*/ 466 h 1865"/>
              <a:gd name="T20" fmla="*/ 1894 w 5341"/>
              <a:gd name="T21" fmla="*/ 0 h 1865"/>
              <a:gd name="T22" fmla="*/ 0 w 5341"/>
              <a:gd name="T23" fmla="*/ 0 h 186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5341" h="1865">
                <a:moveTo>
                  <a:pt x="0" y="0"/>
                </a:moveTo>
                <a:lnTo>
                  <a:pt x="0" y="932"/>
                </a:lnTo>
                <a:lnTo>
                  <a:pt x="0" y="1865"/>
                </a:lnTo>
                <a:lnTo>
                  <a:pt x="623" y="1865"/>
                </a:lnTo>
                <a:lnTo>
                  <a:pt x="623" y="1399"/>
                </a:lnTo>
                <a:lnTo>
                  <a:pt x="5341" y="1399"/>
                </a:lnTo>
                <a:lnTo>
                  <a:pt x="5341" y="777"/>
                </a:lnTo>
                <a:lnTo>
                  <a:pt x="2315" y="777"/>
                </a:lnTo>
                <a:lnTo>
                  <a:pt x="2315" y="466"/>
                </a:lnTo>
                <a:lnTo>
                  <a:pt x="1894" y="466"/>
                </a:lnTo>
                <a:lnTo>
                  <a:pt x="1894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11" name="Freeform 8"/>
          <p:cNvSpPr>
            <a:spLocks/>
          </p:cNvSpPr>
          <p:nvPr/>
        </p:nvSpPr>
        <p:spPr bwMode="auto">
          <a:xfrm>
            <a:off x="5973763" y="1065213"/>
            <a:ext cx="2665413" cy="2016125"/>
          </a:xfrm>
          <a:custGeom>
            <a:avLst/>
            <a:gdLst>
              <a:gd name="T0" fmla="*/ 0 w 9317"/>
              <a:gd name="T1" fmla="*/ 0 h 5287"/>
              <a:gd name="T2" fmla="*/ 0 w 9317"/>
              <a:gd name="T3" fmla="*/ 2643 h 5287"/>
              <a:gd name="T4" fmla="*/ 0 w 9317"/>
              <a:gd name="T5" fmla="*/ 5287 h 5287"/>
              <a:gd name="T6" fmla="*/ 7181 w 9317"/>
              <a:gd name="T7" fmla="*/ 5287 h 5287"/>
              <a:gd name="T8" fmla="*/ 7181 w 9317"/>
              <a:gd name="T9" fmla="*/ 4976 h 5287"/>
              <a:gd name="T10" fmla="*/ 9317 w 9317"/>
              <a:gd name="T11" fmla="*/ 4976 h 5287"/>
              <a:gd name="T12" fmla="*/ 9317 w 9317"/>
              <a:gd name="T13" fmla="*/ 4355 h 5287"/>
              <a:gd name="T14" fmla="*/ 3770 w 9317"/>
              <a:gd name="T15" fmla="*/ 4355 h 5287"/>
              <a:gd name="T16" fmla="*/ 3770 w 9317"/>
              <a:gd name="T17" fmla="*/ 4044 h 5287"/>
              <a:gd name="T18" fmla="*/ 2884 w 9317"/>
              <a:gd name="T19" fmla="*/ 4044 h 5287"/>
              <a:gd name="T20" fmla="*/ 2884 w 9317"/>
              <a:gd name="T21" fmla="*/ 2782 h 5287"/>
              <a:gd name="T22" fmla="*/ 2159 w 9317"/>
              <a:gd name="T23" fmla="*/ 2782 h 5287"/>
              <a:gd name="T24" fmla="*/ 2159 w 9317"/>
              <a:gd name="T25" fmla="*/ 1393 h 5287"/>
              <a:gd name="T26" fmla="*/ 1413 w 9317"/>
              <a:gd name="T27" fmla="*/ 1393 h 5287"/>
              <a:gd name="T28" fmla="*/ 1413 w 9317"/>
              <a:gd name="T29" fmla="*/ 0 h 5287"/>
              <a:gd name="T30" fmla="*/ 0 w 9317"/>
              <a:gd name="T31" fmla="*/ 0 h 528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</a:cxnLst>
            <a:rect l="0" t="0" r="r" b="b"/>
            <a:pathLst>
              <a:path w="9317" h="5287">
                <a:moveTo>
                  <a:pt x="0" y="0"/>
                </a:moveTo>
                <a:lnTo>
                  <a:pt x="0" y="2643"/>
                </a:lnTo>
                <a:lnTo>
                  <a:pt x="0" y="5287"/>
                </a:lnTo>
                <a:lnTo>
                  <a:pt x="7181" y="5287"/>
                </a:lnTo>
                <a:lnTo>
                  <a:pt x="7181" y="4976"/>
                </a:lnTo>
                <a:lnTo>
                  <a:pt x="9317" y="4976"/>
                </a:lnTo>
                <a:lnTo>
                  <a:pt x="9317" y="4355"/>
                </a:lnTo>
                <a:lnTo>
                  <a:pt x="3770" y="4355"/>
                </a:lnTo>
                <a:lnTo>
                  <a:pt x="3770" y="4044"/>
                </a:lnTo>
                <a:lnTo>
                  <a:pt x="2884" y="4044"/>
                </a:lnTo>
                <a:lnTo>
                  <a:pt x="2884" y="2782"/>
                </a:lnTo>
                <a:lnTo>
                  <a:pt x="2159" y="2782"/>
                </a:lnTo>
                <a:lnTo>
                  <a:pt x="2159" y="1393"/>
                </a:lnTo>
                <a:lnTo>
                  <a:pt x="1413" y="1393"/>
                </a:lnTo>
                <a:lnTo>
                  <a:pt x="1413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12" name="Freeform 9"/>
          <p:cNvSpPr>
            <a:spLocks/>
          </p:cNvSpPr>
          <p:nvPr/>
        </p:nvSpPr>
        <p:spPr bwMode="auto">
          <a:xfrm>
            <a:off x="6378576" y="533400"/>
            <a:ext cx="2260600" cy="1062038"/>
          </a:xfrm>
          <a:custGeom>
            <a:avLst/>
            <a:gdLst>
              <a:gd name="T0" fmla="*/ 0 w 7904"/>
              <a:gd name="T1" fmla="*/ 0 h 2787"/>
              <a:gd name="T2" fmla="*/ 0 w 7904"/>
              <a:gd name="T3" fmla="*/ 1394 h 2787"/>
              <a:gd name="T4" fmla="*/ 0 w 7904"/>
              <a:gd name="T5" fmla="*/ 2787 h 2787"/>
              <a:gd name="T6" fmla="*/ 746 w 7904"/>
              <a:gd name="T7" fmla="*/ 2787 h 2787"/>
              <a:gd name="T8" fmla="*/ 746 w 7904"/>
              <a:gd name="T9" fmla="*/ 1398 h 2787"/>
              <a:gd name="T10" fmla="*/ 7904 w 7904"/>
              <a:gd name="T11" fmla="*/ 1398 h 2787"/>
              <a:gd name="T12" fmla="*/ 7904 w 7904"/>
              <a:gd name="T13" fmla="*/ 777 h 2787"/>
              <a:gd name="T14" fmla="*/ 1961 w 7904"/>
              <a:gd name="T15" fmla="*/ 777 h 2787"/>
              <a:gd name="T16" fmla="*/ 1961 w 7904"/>
              <a:gd name="T17" fmla="*/ 466 h 2787"/>
              <a:gd name="T18" fmla="*/ 1217 w 7904"/>
              <a:gd name="T19" fmla="*/ 466 h 2787"/>
              <a:gd name="T20" fmla="*/ 1217 w 7904"/>
              <a:gd name="T21" fmla="*/ 0 h 2787"/>
              <a:gd name="T22" fmla="*/ 0 w 7904"/>
              <a:gd name="T23" fmla="*/ 0 h 278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7904" h="2787">
                <a:moveTo>
                  <a:pt x="0" y="0"/>
                </a:moveTo>
                <a:lnTo>
                  <a:pt x="0" y="1394"/>
                </a:lnTo>
                <a:lnTo>
                  <a:pt x="0" y="2787"/>
                </a:lnTo>
                <a:lnTo>
                  <a:pt x="746" y="2787"/>
                </a:lnTo>
                <a:lnTo>
                  <a:pt x="746" y="1398"/>
                </a:lnTo>
                <a:lnTo>
                  <a:pt x="7904" y="1398"/>
                </a:lnTo>
                <a:lnTo>
                  <a:pt x="7904" y="777"/>
                </a:lnTo>
                <a:lnTo>
                  <a:pt x="1961" y="777"/>
                </a:lnTo>
                <a:lnTo>
                  <a:pt x="1961" y="466"/>
                </a:lnTo>
                <a:lnTo>
                  <a:pt x="1217" y="466"/>
                </a:lnTo>
                <a:lnTo>
                  <a:pt x="1217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13" name="Freeform 10"/>
          <p:cNvSpPr>
            <a:spLocks/>
          </p:cNvSpPr>
          <p:nvPr/>
        </p:nvSpPr>
        <p:spPr bwMode="auto">
          <a:xfrm>
            <a:off x="8599488" y="1778000"/>
            <a:ext cx="39688" cy="236538"/>
          </a:xfrm>
          <a:custGeom>
            <a:avLst/>
            <a:gdLst>
              <a:gd name="T0" fmla="*/ 0 w 137"/>
              <a:gd name="T1" fmla="*/ 0 h 621"/>
              <a:gd name="T2" fmla="*/ 0 w 137"/>
              <a:gd name="T3" fmla="*/ 311 h 621"/>
              <a:gd name="T4" fmla="*/ 0 w 137"/>
              <a:gd name="T5" fmla="*/ 621 h 621"/>
              <a:gd name="T6" fmla="*/ 137 w 137"/>
              <a:gd name="T7" fmla="*/ 621 h 621"/>
              <a:gd name="T8" fmla="*/ 137 w 137"/>
              <a:gd name="T9" fmla="*/ 0 h 621"/>
              <a:gd name="T10" fmla="*/ 0 w 137"/>
              <a:gd name="T11" fmla="*/ 0 h 6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137" h="621">
                <a:moveTo>
                  <a:pt x="0" y="0"/>
                </a:moveTo>
                <a:lnTo>
                  <a:pt x="0" y="311"/>
                </a:lnTo>
                <a:lnTo>
                  <a:pt x="0" y="621"/>
                </a:lnTo>
                <a:lnTo>
                  <a:pt x="137" y="621"/>
                </a:lnTo>
                <a:lnTo>
                  <a:pt x="137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14" name="Freeform 11"/>
          <p:cNvSpPr>
            <a:spLocks/>
          </p:cNvSpPr>
          <p:nvPr/>
        </p:nvSpPr>
        <p:spPr bwMode="auto">
          <a:xfrm>
            <a:off x="6591301" y="1066800"/>
            <a:ext cx="2047875" cy="1058863"/>
          </a:xfrm>
          <a:custGeom>
            <a:avLst/>
            <a:gdLst>
              <a:gd name="T0" fmla="*/ 0 w 7158"/>
              <a:gd name="T1" fmla="*/ 0 h 2778"/>
              <a:gd name="T2" fmla="*/ 0 w 7158"/>
              <a:gd name="T3" fmla="*/ 1389 h 2778"/>
              <a:gd name="T4" fmla="*/ 0 w 7158"/>
              <a:gd name="T5" fmla="*/ 2778 h 2778"/>
              <a:gd name="T6" fmla="*/ 725 w 7158"/>
              <a:gd name="T7" fmla="*/ 2778 h 2778"/>
              <a:gd name="T8" fmla="*/ 725 w 7158"/>
              <a:gd name="T9" fmla="*/ 1515 h 2778"/>
              <a:gd name="T10" fmla="*/ 6375 w 7158"/>
              <a:gd name="T11" fmla="*/ 1515 h 2778"/>
              <a:gd name="T12" fmla="*/ 6375 w 7158"/>
              <a:gd name="T13" fmla="*/ 622 h 2778"/>
              <a:gd name="T14" fmla="*/ 7158 w 7158"/>
              <a:gd name="T15" fmla="*/ 622 h 2778"/>
              <a:gd name="T16" fmla="*/ 7158 w 7158"/>
              <a:gd name="T17" fmla="*/ 0 h 2778"/>
              <a:gd name="T18" fmla="*/ 0 w 7158"/>
              <a:gd name="T19" fmla="*/ 0 h 27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7158" h="2778">
                <a:moveTo>
                  <a:pt x="0" y="0"/>
                </a:moveTo>
                <a:lnTo>
                  <a:pt x="0" y="1389"/>
                </a:lnTo>
                <a:lnTo>
                  <a:pt x="0" y="2778"/>
                </a:lnTo>
                <a:lnTo>
                  <a:pt x="725" y="2778"/>
                </a:lnTo>
                <a:lnTo>
                  <a:pt x="725" y="1515"/>
                </a:lnTo>
                <a:lnTo>
                  <a:pt x="6375" y="1515"/>
                </a:lnTo>
                <a:lnTo>
                  <a:pt x="6375" y="622"/>
                </a:lnTo>
                <a:lnTo>
                  <a:pt x="7158" y="622"/>
                </a:lnTo>
                <a:lnTo>
                  <a:pt x="7158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15" name="Freeform 12"/>
          <p:cNvSpPr>
            <a:spLocks/>
          </p:cNvSpPr>
          <p:nvPr/>
        </p:nvSpPr>
        <p:spPr bwMode="auto">
          <a:xfrm>
            <a:off x="5972176" y="3614738"/>
            <a:ext cx="2667000" cy="1585913"/>
          </a:xfrm>
          <a:custGeom>
            <a:avLst/>
            <a:gdLst>
              <a:gd name="T0" fmla="*/ 0 w 9325"/>
              <a:gd name="T1" fmla="*/ 0 h 4157"/>
              <a:gd name="T2" fmla="*/ 0 w 9325"/>
              <a:gd name="T3" fmla="*/ 2078 h 4157"/>
              <a:gd name="T4" fmla="*/ 0 w 9325"/>
              <a:gd name="T5" fmla="*/ 4157 h 4157"/>
              <a:gd name="T6" fmla="*/ 2513 w 9325"/>
              <a:gd name="T7" fmla="*/ 4157 h 4157"/>
              <a:gd name="T8" fmla="*/ 2513 w 9325"/>
              <a:gd name="T9" fmla="*/ 2409 h 4157"/>
              <a:gd name="T10" fmla="*/ 4420 w 9325"/>
              <a:gd name="T11" fmla="*/ 2409 h 4157"/>
              <a:gd name="T12" fmla="*/ 4420 w 9325"/>
              <a:gd name="T13" fmla="*/ 1709 h 4157"/>
              <a:gd name="T14" fmla="*/ 4785 w 9325"/>
              <a:gd name="T15" fmla="*/ 1709 h 4157"/>
              <a:gd name="T16" fmla="*/ 4785 w 9325"/>
              <a:gd name="T17" fmla="*/ 1399 h 4157"/>
              <a:gd name="T18" fmla="*/ 9325 w 9325"/>
              <a:gd name="T19" fmla="*/ 1399 h 4157"/>
              <a:gd name="T20" fmla="*/ 9325 w 9325"/>
              <a:gd name="T21" fmla="*/ 777 h 4157"/>
              <a:gd name="T22" fmla="*/ 1684 w 9325"/>
              <a:gd name="T23" fmla="*/ 777 h 4157"/>
              <a:gd name="T24" fmla="*/ 1684 w 9325"/>
              <a:gd name="T25" fmla="*/ 466 h 4157"/>
              <a:gd name="T26" fmla="*/ 631 w 9325"/>
              <a:gd name="T27" fmla="*/ 466 h 4157"/>
              <a:gd name="T28" fmla="*/ 631 w 9325"/>
              <a:gd name="T29" fmla="*/ 0 h 4157"/>
              <a:gd name="T30" fmla="*/ 0 w 9325"/>
              <a:gd name="T31" fmla="*/ 0 h 41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</a:cxnLst>
            <a:rect l="0" t="0" r="r" b="b"/>
            <a:pathLst>
              <a:path w="9325" h="4157">
                <a:moveTo>
                  <a:pt x="0" y="0"/>
                </a:moveTo>
                <a:lnTo>
                  <a:pt x="0" y="2078"/>
                </a:lnTo>
                <a:lnTo>
                  <a:pt x="0" y="4157"/>
                </a:lnTo>
                <a:lnTo>
                  <a:pt x="2513" y="4157"/>
                </a:lnTo>
                <a:lnTo>
                  <a:pt x="2513" y="2409"/>
                </a:lnTo>
                <a:lnTo>
                  <a:pt x="4420" y="2409"/>
                </a:lnTo>
                <a:lnTo>
                  <a:pt x="4420" y="1709"/>
                </a:lnTo>
                <a:lnTo>
                  <a:pt x="4785" y="1709"/>
                </a:lnTo>
                <a:lnTo>
                  <a:pt x="4785" y="1399"/>
                </a:lnTo>
                <a:lnTo>
                  <a:pt x="9325" y="1399"/>
                </a:lnTo>
                <a:lnTo>
                  <a:pt x="9325" y="777"/>
                </a:lnTo>
                <a:lnTo>
                  <a:pt x="1684" y="777"/>
                </a:lnTo>
                <a:lnTo>
                  <a:pt x="1684" y="466"/>
                </a:lnTo>
                <a:lnTo>
                  <a:pt x="631" y="466"/>
                </a:lnTo>
                <a:lnTo>
                  <a:pt x="631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16" name="Freeform 13"/>
          <p:cNvSpPr>
            <a:spLocks/>
          </p:cNvSpPr>
          <p:nvPr/>
        </p:nvSpPr>
        <p:spPr bwMode="auto">
          <a:xfrm>
            <a:off x="6799263" y="1644650"/>
            <a:ext cx="1839913" cy="962025"/>
          </a:xfrm>
          <a:custGeom>
            <a:avLst/>
            <a:gdLst>
              <a:gd name="T0" fmla="*/ 0 w 6433"/>
              <a:gd name="T1" fmla="*/ 0 h 2525"/>
              <a:gd name="T2" fmla="*/ 0 w 6433"/>
              <a:gd name="T3" fmla="*/ 1263 h 2525"/>
              <a:gd name="T4" fmla="*/ 0 w 6433"/>
              <a:gd name="T5" fmla="*/ 2525 h 2525"/>
              <a:gd name="T6" fmla="*/ 886 w 6433"/>
              <a:gd name="T7" fmla="*/ 2525 h 2525"/>
              <a:gd name="T8" fmla="*/ 886 w 6433"/>
              <a:gd name="T9" fmla="*/ 2214 h 2525"/>
              <a:gd name="T10" fmla="*/ 6433 w 6433"/>
              <a:gd name="T11" fmla="*/ 2214 h 2525"/>
              <a:gd name="T12" fmla="*/ 6433 w 6433"/>
              <a:gd name="T13" fmla="*/ 1593 h 2525"/>
              <a:gd name="T14" fmla="*/ 6243 w 6433"/>
              <a:gd name="T15" fmla="*/ 1593 h 2525"/>
              <a:gd name="T16" fmla="*/ 6243 w 6433"/>
              <a:gd name="T17" fmla="*/ 894 h 2525"/>
              <a:gd name="T18" fmla="*/ 5650 w 6433"/>
              <a:gd name="T19" fmla="*/ 894 h 2525"/>
              <a:gd name="T20" fmla="*/ 5650 w 6433"/>
              <a:gd name="T21" fmla="*/ 0 h 2525"/>
              <a:gd name="T22" fmla="*/ 0 w 6433"/>
              <a:gd name="T23" fmla="*/ 0 h 252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</a:cxnLst>
            <a:rect l="0" t="0" r="r" b="b"/>
            <a:pathLst>
              <a:path w="6433" h="2525">
                <a:moveTo>
                  <a:pt x="0" y="0"/>
                </a:moveTo>
                <a:lnTo>
                  <a:pt x="0" y="1263"/>
                </a:lnTo>
                <a:lnTo>
                  <a:pt x="0" y="2525"/>
                </a:lnTo>
                <a:lnTo>
                  <a:pt x="886" y="2525"/>
                </a:lnTo>
                <a:lnTo>
                  <a:pt x="886" y="2214"/>
                </a:lnTo>
                <a:lnTo>
                  <a:pt x="6433" y="2214"/>
                </a:lnTo>
                <a:lnTo>
                  <a:pt x="6433" y="1593"/>
                </a:lnTo>
                <a:lnTo>
                  <a:pt x="6243" y="1593"/>
                </a:lnTo>
                <a:lnTo>
                  <a:pt x="6243" y="894"/>
                </a:lnTo>
                <a:lnTo>
                  <a:pt x="5650" y="894"/>
                </a:lnTo>
                <a:lnTo>
                  <a:pt x="5650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17" name="Freeform 14"/>
          <p:cNvSpPr>
            <a:spLocks/>
          </p:cNvSpPr>
          <p:nvPr/>
        </p:nvSpPr>
        <p:spPr bwMode="auto">
          <a:xfrm>
            <a:off x="7315201" y="4622800"/>
            <a:ext cx="1323975" cy="355600"/>
          </a:xfrm>
          <a:custGeom>
            <a:avLst/>
            <a:gdLst>
              <a:gd name="T0" fmla="*/ 0 w 4629"/>
              <a:gd name="T1" fmla="*/ 0 h 932"/>
              <a:gd name="T2" fmla="*/ 0 w 4629"/>
              <a:gd name="T3" fmla="*/ 466 h 932"/>
              <a:gd name="T4" fmla="*/ 0 w 4629"/>
              <a:gd name="T5" fmla="*/ 932 h 932"/>
              <a:gd name="T6" fmla="*/ 75 w 4629"/>
              <a:gd name="T7" fmla="*/ 932 h 932"/>
              <a:gd name="T8" fmla="*/ 75 w 4629"/>
              <a:gd name="T9" fmla="*/ 621 h 932"/>
              <a:gd name="T10" fmla="*/ 4629 w 4629"/>
              <a:gd name="T11" fmla="*/ 621 h 932"/>
              <a:gd name="T12" fmla="*/ 4629 w 4629"/>
              <a:gd name="T13" fmla="*/ 0 h 932"/>
              <a:gd name="T14" fmla="*/ 0 w 4629"/>
              <a:gd name="T15" fmla="*/ 0 h 9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4629" h="932">
                <a:moveTo>
                  <a:pt x="0" y="0"/>
                </a:moveTo>
                <a:lnTo>
                  <a:pt x="0" y="466"/>
                </a:lnTo>
                <a:lnTo>
                  <a:pt x="0" y="932"/>
                </a:lnTo>
                <a:lnTo>
                  <a:pt x="75" y="932"/>
                </a:lnTo>
                <a:lnTo>
                  <a:pt x="75" y="621"/>
                </a:lnTo>
                <a:lnTo>
                  <a:pt x="4629" y="621"/>
                </a:lnTo>
                <a:lnTo>
                  <a:pt x="4629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18" name="Freeform 15"/>
          <p:cNvSpPr>
            <a:spLocks/>
          </p:cNvSpPr>
          <p:nvPr/>
        </p:nvSpPr>
        <p:spPr bwMode="auto">
          <a:xfrm>
            <a:off x="6153151" y="3436938"/>
            <a:ext cx="2486025" cy="355600"/>
          </a:xfrm>
          <a:custGeom>
            <a:avLst/>
            <a:gdLst>
              <a:gd name="T0" fmla="*/ 0 w 8694"/>
              <a:gd name="T1" fmla="*/ 0 h 932"/>
              <a:gd name="T2" fmla="*/ 0 w 8694"/>
              <a:gd name="T3" fmla="*/ 466 h 932"/>
              <a:gd name="T4" fmla="*/ 0 w 8694"/>
              <a:gd name="T5" fmla="*/ 932 h 932"/>
              <a:gd name="T6" fmla="*/ 1053 w 8694"/>
              <a:gd name="T7" fmla="*/ 932 h 932"/>
              <a:gd name="T8" fmla="*/ 1053 w 8694"/>
              <a:gd name="T9" fmla="*/ 622 h 932"/>
              <a:gd name="T10" fmla="*/ 8694 w 8694"/>
              <a:gd name="T11" fmla="*/ 622 h 932"/>
              <a:gd name="T12" fmla="*/ 8694 w 8694"/>
              <a:gd name="T13" fmla="*/ 0 h 932"/>
              <a:gd name="T14" fmla="*/ 0 w 8694"/>
              <a:gd name="T15" fmla="*/ 0 h 9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8694" h="932">
                <a:moveTo>
                  <a:pt x="0" y="0"/>
                </a:moveTo>
                <a:lnTo>
                  <a:pt x="0" y="466"/>
                </a:lnTo>
                <a:lnTo>
                  <a:pt x="0" y="932"/>
                </a:lnTo>
                <a:lnTo>
                  <a:pt x="1053" y="932"/>
                </a:lnTo>
                <a:lnTo>
                  <a:pt x="1053" y="622"/>
                </a:lnTo>
                <a:lnTo>
                  <a:pt x="8694" y="622"/>
                </a:lnTo>
                <a:lnTo>
                  <a:pt x="8694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19" name="Freeform 16"/>
          <p:cNvSpPr>
            <a:spLocks/>
          </p:cNvSpPr>
          <p:nvPr/>
        </p:nvSpPr>
        <p:spPr bwMode="auto">
          <a:xfrm>
            <a:off x="7235826" y="4267200"/>
            <a:ext cx="1403350" cy="533400"/>
          </a:xfrm>
          <a:custGeom>
            <a:avLst/>
            <a:gdLst>
              <a:gd name="T0" fmla="*/ 0 w 4905"/>
              <a:gd name="T1" fmla="*/ 0 h 1399"/>
              <a:gd name="T2" fmla="*/ 0 w 4905"/>
              <a:gd name="T3" fmla="*/ 700 h 1399"/>
              <a:gd name="T4" fmla="*/ 0 w 4905"/>
              <a:gd name="T5" fmla="*/ 1399 h 1399"/>
              <a:gd name="T6" fmla="*/ 276 w 4905"/>
              <a:gd name="T7" fmla="*/ 1399 h 1399"/>
              <a:gd name="T8" fmla="*/ 276 w 4905"/>
              <a:gd name="T9" fmla="*/ 933 h 1399"/>
              <a:gd name="T10" fmla="*/ 4905 w 4905"/>
              <a:gd name="T11" fmla="*/ 933 h 1399"/>
              <a:gd name="T12" fmla="*/ 4905 w 4905"/>
              <a:gd name="T13" fmla="*/ 311 h 1399"/>
              <a:gd name="T14" fmla="*/ 365 w 4905"/>
              <a:gd name="T15" fmla="*/ 311 h 1399"/>
              <a:gd name="T16" fmla="*/ 365 w 4905"/>
              <a:gd name="T17" fmla="*/ 0 h 1399"/>
              <a:gd name="T18" fmla="*/ 0 w 4905"/>
              <a:gd name="T19" fmla="*/ 0 h 139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4905" h="1399">
                <a:moveTo>
                  <a:pt x="0" y="0"/>
                </a:moveTo>
                <a:lnTo>
                  <a:pt x="0" y="700"/>
                </a:lnTo>
                <a:lnTo>
                  <a:pt x="0" y="1399"/>
                </a:lnTo>
                <a:lnTo>
                  <a:pt x="276" y="1399"/>
                </a:lnTo>
                <a:lnTo>
                  <a:pt x="276" y="933"/>
                </a:lnTo>
                <a:lnTo>
                  <a:pt x="4905" y="933"/>
                </a:lnTo>
                <a:lnTo>
                  <a:pt x="4905" y="311"/>
                </a:lnTo>
                <a:lnTo>
                  <a:pt x="365" y="311"/>
                </a:lnTo>
                <a:lnTo>
                  <a:pt x="365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20" name="Freeform 17"/>
          <p:cNvSpPr>
            <a:spLocks/>
          </p:cNvSpPr>
          <p:nvPr/>
        </p:nvSpPr>
        <p:spPr bwMode="auto">
          <a:xfrm>
            <a:off x="5734051" y="2073275"/>
            <a:ext cx="2905125" cy="2333625"/>
          </a:xfrm>
          <a:custGeom>
            <a:avLst/>
            <a:gdLst>
              <a:gd name="T0" fmla="*/ 0 w 10157"/>
              <a:gd name="T1" fmla="*/ 0 h 6120"/>
              <a:gd name="T2" fmla="*/ 0 w 10157"/>
              <a:gd name="T3" fmla="*/ 3060 h 6120"/>
              <a:gd name="T4" fmla="*/ 0 w 10157"/>
              <a:gd name="T5" fmla="*/ 6120 h 6120"/>
              <a:gd name="T6" fmla="*/ 832 w 10157"/>
              <a:gd name="T7" fmla="*/ 6120 h 6120"/>
              <a:gd name="T8" fmla="*/ 832 w 10157"/>
              <a:gd name="T9" fmla="*/ 4042 h 6120"/>
              <a:gd name="T10" fmla="*/ 1463 w 10157"/>
              <a:gd name="T11" fmla="*/ 4042 h 6120"/>
              <a:gd name="T12" fmla="*/ 1463 w 10157"/>
              <a:gd name="T13" fmla="*/ 3576 h 6120"/>
              <a:gd name="T14" fmla="*/ 10157 w 10157"/>
              <a:gd name="T15" fmla="*/ 3576 h 6120"/>
              <a:gd name="T16" fmla="*/ 10157 w 10157"/>
              <a:gd name="T17" fmla="*/ 2955 h 6120"/>
              <a:gd name="T18" fmla="*/ 8021 w 10157"/>
              <a:gd name="T19" fmla="*/ 2955 h 6120"/>
              <a:gd name="T20" fmla="*/ 8021 w 10157"/>
              <a:gd name="T21" fmla="*/ 2644 h 6120"/>
              <a:gd name="T22" fmla="*/ 840 w 10157"/>
              <a:gd name="T23" fmla="*/ 2644 h 6120"/>
              <a:gd name="T24" fmla="*/ 840 w 10157"/>
              <a:gd name="T25" fmla="*/ 0 h 6120"/>
              <a:gd name="T26" fmla="*/ 0 w 10157"/>
              <a:gd name="T27" fmla="*/ 0 h 612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10157" h="6120">
                <a:moveTo>
                  <a:pt x="0" y="0"/>
                </a:moveTo>
                <a:lnTo>
                  <a:pt x="0" y="3060"/>
                </a:lnTo>
                <a:lnTo>
                  <a:pt x="0" y="6120"/>
                </a:lnTo>
                <a:lnTo>
                  <a:pt x="832" y="6120"/>
                </a:lnTo>
                <a:lnTo>
                  <a:pt x="832" y="4042"/>
                </a:lnTo>
                <a:lnTo>
                  <a:pt x="1463" y="4042"/>
                </a:lnTo>
                <a:lnTo>
                  <a:pt x="1463" y="3576"/>
                </a:lnTo>
                <a:lnTo>
                  <a:pt x="10157" y="3576"/>
                </a:lnTo>
                <a:lnTo>
                  <a:pt x="10157" y="2955"/>
                </a:lnTo>
                <a:lnTo>
                  <a:pt x="8021" y="2955"/>
                </a:lnTo>
                <a:lnTo>
                  <a:pt x="8021" y="2644"/>
                </a:lnTo>
                <a:lnTo>
                  <a:pt x="840" y="2644"/>
                </a:lnTo>
                <a:lnTo>
                  <a:pt x="840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21" name="Freeform 18"/>
          <p:cNvSpPr>
            <a:spLocks/>
          </p:cNvSpPr>
          <p:nvPr/>
        </p:nvSpPr>
        <p:spPr bwMode="auto">
          <a:xfrm>
            <a:off x="8583613" y="1717675"/>
            <a:ext cx="55563" cy="533400"/>
          </a:xfrm>
          <a:custGeom>
            <a:avLst/>
            <a:gdLst>
              <a:gd name="T0" fmla="*/ 0 w 190"/>
              <a:gd name="T1" fmla="*/ 0 h 1398"/>
              <a:gd name="T2" fmla="*/ 0 w 190"/>
              <a:gd name="T3" fmla="*/ 699 h 1398"/>
              <a:gd name="T4" fmla="*/ 0 w 190"/>
              <a:gd name="T5" fmla="*/ 1398 h 1398"/>
              <a:gd name="T6" fmla="*/ 190 w 190"/>
              <a:gd name="T7" fmla="*/ 1398 h 1398"/>
              <a:gd name="T8" fmla="*/ 190 w 190"/>
              <a:gd name="T9" fmla="*/ 776 h 1398"/>
              <a:gd name="T10" fmla="*/ 53 w 190"/>
              <a:gd name="T11" fmla="*/ 776 h 1398"/>
              <a:gd name="T12" fmla="*/ 53 w 190"/>
              <a:gd name="T13" fmla="*/ 466 h 1398"/>
              <a:gd name="T14" fmla="*/ 35 w 190"/>
              <a:gd name="T15" fmla="*/ 466 h 1398"/>
              <a:gd name="T16" fmla="*/ 35 w 190"/>
              <a:gd name="T17" fmla="*/ 0 h 1398"/>
              <a:gd name="T18" fmla="*/ 0 w 190"/>
              <a:gd name="T19" fmla="*/ 0 h 139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190" h="1398">
                <a:moveTo>
                  <a:pt x="0" y="0"/>
                </a:moveTo>
                <a:lnTo>
                  <a:pt x="0" y="699"/>
                </a:lnTo>
                <a:lnTo>
                  <a:pt x="0" y="1398"/>
                </a:lnTo>
                <a:lnTo>
                  <a:pt x="190" y="1398"/>
                </a:lnTo>
                <a:lnTo>
                  <a:pt x="190" y="776"/>
                </a:lnTo>
                <a:lnTo>
                  <a:pt x="53" y="776"/>
                </a:lnTo>
                <a:lnTo>
                  <a:pt x="53" y="466"/>
                </a:lnTo>
                <a:lnTo>
                  <a:pt x="35" y="466"/>
                </a:lnTo>
                <a:lnTo>
                  <a:pt x="35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22" name="Freeform 19"/>
          <p:cNvSpPr>
            <a:spLocks/>
          </p:cNvSpPr>
          <p:nvPr/>
        </p:nvSpPr>
        <p:spPr bwMode="auto">
          <a:xfrm>
            <a:off x="8415338" y="1303338"/>
            <a:ext cx="223838" cy="681038"/>
          </a:xfrm>
          <a:custGeom>
            <a:avLst/>
            <a:gdLst>
              <a:gd name="T0" fmla="*/ 0 w 783"/>
              <a:gd name="T1" fmla="*/ 0 h 1787"/>
              <a:gd name="T2" fmla="*/ 0 w 783"/>
              <a:gd name="T3" fmla="*/ 893 h 1787"/>
              <a:gd name="T4" fmla="*/ 0 w 783"/>
              <a:gd name="T5" fmla="*/ 1787 h 1787"/>
              <a:gd name="T6" fmla="*/ 593 w 783"/>
              <a:gd name="T7" fmla="*/ 1787 h 1787"/>
              <a:gd name="T8" fmla="*/ 593 w 783"/>
              <a:gd name="T9" fmla="*/ 1088 h 1787"/>
              <a:gd name="T10" fmla="*/ 628 w 783"/>
              <a:gd name="T11" fmla="*/ 1088 h 1787"/>
              <a:gd name="T12" fmla="*/ 628 w 783"/>
              <a:gd name="T13" fmla="*/ 621 h 1787"/>
              <a:gd name="T14" fmla="*/ 783 w 783"/>
              <a:gd name="T15" fmla="*/ 621 h 1787"/>
              <a:gd name="T16" fmla="*/ 783 w 783"/>
              <a:gd name="T17" fmla="*/ 0 h 1787"/>
              <a:gd name="T18" fmla="*/ 0 w 783"/>
              <a:gd name="T19" fmla="*/ 0 h 178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</a:cxnLst>
            <a:rect l="0" t="0" r="r" b="b"/>
            <a:pathLst>
              <a:path w="783" h="1787">
                <a:moveTo>
                  <a:pt x="0" y="0"/>
                </a:moveTo>
                <a:lnTo>
                  <a:pt x="0" y="893"/>
                </a:lnTo>
                <a:lnTo>
                  <a:pt x="0" y="1787"/>
                </a:lnTo>
                <a:lnTo>
                  <a:pt x="593" y="1787"/>
                </a:lnTo>
                <a:lnTo>
                  <a:pt x="593" y="1088"/>
                </a:lnTo>
                <a:lnTo>
                  <a:pt x="628" y="1088"/>
                </a:lnTo>
                <a:lnTo>
                  <a:pt x="628" y="621"/>
                </a:lnTo>
                <a:lnTo>
                  <a:pt x="783" y="621"/>
                </a:lnTo>
                <a:lnTo>
                  <a:pt x="783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23" name="Freeform 20"/>
          <p:cNvSpPr>
            <a:spLocks/>
          </p:cNvSpPr>
          <p:nvPr/>
        </p:nvSpPr>
        <p:spPr bwMode="auto">
          <a:xfrm>
            <a:off x="7773988" y="5570538"/>
            <a:ext cx="865188" cy="236538"/>
          </a:xfrm>
          <a:custGeom>
            <a:avLst/>
            <a:gdLst>
              <a:gd name="T0" fmla="*/ 0 w 3026"/>
              <a:gd name="T1" fmla="*/ 0 h 621"/>
              <a:gd name="T2" fmla="*/ 0 w 3026"/>
              <a:gd name="T3" fmla="*/ 310 h 621"/>
              <a:gd name="T4" fmla="*/ 0 w 3026"/>
              <a:gd name="T5" fmla="*/ 621 h 621"/>
              <a:gd name="T6" fmla="*/ 3026 w 3026"/>
              <a:gd name="T7" fmla="*/ 621 h 621"/>
              <a:gd name="T8" fmla="*/ 3026 w 3026"/>
              <a:gd name="T9" fmla="*/ 0 h 621"/>
              <a:gd name="T10" fmla="*/ 0 w 3026"/>
              <a:gd name="T11" fmla="*/ 0 h 6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3026" h="621">
                <a:moveTo>
                  <a:pt x="0" y="0"/>
                </a:moveTo>
                <a:lnTo>
                  <a:pt x="0" y="310"/>
                </a:lnTo>
                <a:lnTo>
                  <a:pt x="0" y="621"/>
                </a:lnTo>
                <a:lnTo>
                  <a:pt x="3026" y="621"/>
                </a:lnTo>
                <a:lnTo>
                  <a:pt x="3026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24" name="Freeform 21"/>
          <p:cNvSpPr>
            <a:spLocks/>
          </p:cNvSpPr>
          <p:nvPr/>
        </p:nvSpPr>
        <p:spPr bwMode="auto">
          <a:xfrm>
            <a:off x="6691313" y="4533900"/>
            <a:ext cx="1947863" cy="1331913"/>
          </a:xfrm>
          <a:custGeom>
            <a:avLst/>
            <a:gdLst>
              <a:gd name="T0" fmla="*/ 0 w 6812"/>
              <a:gd name="T1" fmla="*/ 0 h 3495"/>
              <a:gd name="T2" fmla="*/ 0 w 6812"/>
              <a:gd name="T3" fmla="*/ 1748 h 3495"/>
              <a:gd name="T4" fmla="*/ 0 w 6812"/>
              <a:gd name="T5" fmla="*/ 3495 h 3495"/>
              <a:gd name="T6" fmla="*/ 1471 w 6812"/>
              <a:gd name="T7" fmla="*/ 3495 h 3495"/>
              <a:gd name="T8" fmla="*/ 1471 w 6812"/>
              <a:gd name="T9" fmla="*/ 2563 h 3495"/>
              <a:gd name="T10" fmla="*/ 3365 w 6812"/>
              <a:gd name="T11" fmla="*/ 2563 h 3495"/>
              <a:gd name="T12" fmla="*/ 3365 w 6812"/>
              <a:gd name="T13" fmla="*/ 2097 h 3495"/>
              <a:gd name="T14" fmla="*/ 6812 w 6812"/>
              <a:gd name="T15" fmla="*/ 2097 h 3495"/>
              <a:gd name="T16" fmla="*/ 6812 w 6812"/>
              <a:gd name="T17" fmla="*/ 1476 h 3495"/>
              <a:gd name="T18" fmla="*/ 2258 w 6812"/>
              <a:gd name="T19" fmla="*/ 1476 h 3495"/>
              <a:gd name="T20" fmla="*/ 2258 w 6812"/>
              <a:gd name="T21" fmla="*/ 1165 h 3495"/>
              <a:gd name="T22" fmla="*/ 2183 w 6812"/>
              <a:gd name="T23" fmla="*/ 1165 h 3495"/>
              <a:gd name="T24" fmla="*/ 2183 w 6812"/>
              <a:gd name="T25" fmla="*/ 699 h 3495"/>
              <a:gd name="T26" fmla="*/ 1907 w 6812"/>
              <a:gd name="T27" fmla="*/ 699 h 3495"/>
              <a:gd name="T28" fmla="*/ 1907 w 6812"/>
              <a:gd name="T29" fmla="*/ 0 h 3495"/>
              <a:gd name="T30" fmla="*/ 0 w 6812"/>
              <a:gd name="T31" fmla="*/ 0 h 349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  <a:cxn ang="0">
                <a:pos x="T28" y="T29"/>
              </a:cxn>
              <a:cxn ang="0">
                <a:pos x="T30" y="T31"/>
              </a:cxn>
            </a:cxnLst>
            <a:rect l="0" t="0" r="r" b="b"/>
            <a:pathLst>
              <a:path w="6812" h="3495">
                <a:moveTo>
                  <a:pt x="0" y="0"/>
                </a:moveTo>
                <a:lnTo>
                  <a:pt x="0" y="1748"/>
                </a:lnTo>
                <a:lnTo>
                  <a:pt x="0" y="3495"/>
                </a:lnTo>
                <a:lnTo>
                  <a:pt x="1471" y="3495"/>
                </a:lnTo>
                <a:lnTo>
                  <a:pt x="1471" y="2563"/>
                </a:lnTo>
                <a:lnTo>
                  <a:pt x="3365" y="2563"/>
                </a:lnTo>
                <a:lnTo>
                  <a:pt x="3365" y="2097"/>
                </a:lnTo>
                <a:lnTo>
                  <a:pt x="6812" y="2097"/>
                </a:lnTo>
                <a:lnTo>
                  <a:pt x="6812" y="1476"/>
                </a:lnTo>
                <a:lnTo>
                  <a:pt x="2258" y="1476"/>
                </a:lnTo>
                <a:lnTo>
                  <a:pt x="2258" y="1165"/>
                </a:lnTo>
                <a:lnTo>
                  <a:pt x="2183" y="1165"/>
                </a:lnTo>
                <a:lnTo>
                  <a:pt x="2183" y="699"/>
                </a:lnTo>
                <a:lnTo>
                  <a:pt x="1907" y="699"/>
                </a:lnTo>
                <a:lnTo>
                  <a:pt x="1907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25" name="Freeform 22"/>
          <p:cNvSpPr>
            <a:spLocks/>
          </p:cNvSpPr>
          <p:nvPr/>
        </p:nvSpPr>
        <p:spPr bwMode="auto">
          <a:xfrm>
            <a:off x="7337426" y="6281738"/>
            <a:ext cx="1301750" cy="236538"/>
          </a:xfrm>
          <a:custGeom>
            <a:avLst/>
            <a:gdLst>
              <a:gd name="T0" fmla="*/ 0 w 4552"/>
              <a:gd name="T1" fmla="*/ 0 h 622"/>
              <a:gd name="T2" fmla="*/ 0 w 4552"/>
              <a:gd name="T3" fmla="*/ 311 h 622"/>
              <a:gd name="T4" fmla="*/ 0 w 4552"/>
              <a:gd name="T5" fmla="*/ 622 h 622"/>
              <a:gd name="T6" fmla="*/ 4552 w 4552"/>
              <a:gd name="T7" fmla="*/ 622 h 622"/>
              <a:gd name="T8" fmla="*/ 4552 w 4552"/>
              <a:gd name="T9" fmla="*/ 0 h 622"/>
              <a:gd name="T10" fmla="*/ 0 w 4552"/>
              <a:gd name="T11" fmla="*/ 0 h 6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552" h="622">
                <a:moveTo>
                  <a:pt x="0" y="0"/>
                </a:moveTo>
                <a:lnTo>
                  <a:pt x="0" y="311"/>
                </a:lnTo>
                <a:lnTo>
                  <a:pt x="0" y="622"/>
                </a:lnTo>
                <a:lnTo>
                  <a:pt x="4552" y="622"/>
                </a:lnTo>
                <a:lnTo>
                  <a:pt x="4552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26" name="Freeform 23"/>
          <p:cNvSpPr>
            <a:spLocks/>
          </p:cNvSpPr>
          <p:nvPr/>
        </p:nvSpPr>
        <p:spPr bwMode="auto">
          <a:xfrm>
            <a:off x="7340601" y="4148138"/>
            <a:ext cx="1298575" cy="236538"/>
          </a:xfrm>
          <a:custGeom>
            <a:avLst/>
            <a:gdLst>
              <a:gd name="T0" fmla="*/ 0 w 4540"/>
              <a:gd name="T1" fmla="*/ 0 h 621"/>
              <a:gd name="T2" fmla="*/ 0 w 4540"/>
              <a:gd name="T3" fmla="*/ 310 h 621"/>
              <a:gd name="T4" fmla="*/ 0 w 4540"/>
              <a:gd name="T5" fmla="*/ 621 h 621"/>
              <a:gd name="T6" fmla="*/ 4540 w 4540"/>
              <a:gd name="T7" fmla="*/ 621 h 621"/>
              <a:gd name="T8" fmla="*/ 4540 w 4540"/>
              <a:gd name="T9" fmla="*/ 0 h 621"/>
              <a:gd name="T10" fmla="*/ 0 w 4540"/>
              <a:gd name="T11" fmla="*/ 0 h 6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540" h="621">
                <a:moveTo>
                  <a:pt x="0" y="0"/>
                </a:moveTo>
                <a:lnTo>
                  <a:pt x="0" y="310"/>
                </a:lnTo>
                <a:lnTo>
                  <a:pt x="0" y="621"/>
                </a:lnTo>
                <a:lnTo>
                  <a:pt x="4540" y="621"/>
                </a:lnTo>
                <a:lnTo>
                  <a:pt x="4540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27" name="Freeform 24"/>
          <p:cNvSpPr>
            <a:spLocks/>
          </p:cNvSpPr>
          <p:nvPr/>
        </p:nvSpPr>
        <p:spPr bwMode="auto">
          <a:xfrm>
            <a:off x="6938963" y="592138"/>
            <a:ext cx="1700213" cy="236538"/>
          </a:xfrm>
          <a:custGeom>
            <a:avLst/>
            <a:gdLst>
              <a:gd name="T0" fmla="*/ 0 w 5943"/>
              <a:gd name="T1" fmla="*/ 0 h 622"/>
              <a:gd name="T2" fmla="*/ 0 w 5943"/>
              <a:gd name="T3" fmla="*/ 311 h 622"/>
              <a:gd name="T4" fmla="*/ 0 w 5943"/>
              <a:gd name="T5" fmla="*/ 622 h 622"/>
              <a:gd name="T6" fmla="*/ 5943 w 5943"/>
              <a:gd name="T7" fmla="*/ 622 h 622"/>
              <a:gd name="T8" fmla="*/ 5943 w 5943"/>
              <a:gd name="T9" fmla="*/ 0 h 622"/>
              <a:gd name="T10" fmla="*/ 0 w 5943"/>
              <a:gd name="T11" fmla="*/ 0 h 6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943" h="622">
                <a:moveTo>
                  <a:pt x="0" y="0"/>
                </a:moveTo>
                <a:lnTo>
                  <a:pt x="0" y="311"/>
                </a:lnTo>
                <a:lnTo>
                  <a:pt x="0" y="622"/>
                </a:lnTo>
                <a:lnTo>
                  <a:pt x="5943" y="622"/>
                </a:lnTo>
                <a:lnTo>
                  <a:pt x="5943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28" name="Freeform 25"/>
          <p:cNvSpPr>
            <a:spLocks/>
          </p:cNvSpPr>
          <p:nvPr/>
        </p:nvSpPr>
        <p:spPr bwMode="auto">
          <a:xfrm>
            <a:off x="7653338" y="5334000"/>
            <a:ext cx="985838" cy="355600"/>
          </a:xfrm>
          <a:custGeom>
            <a:avLst/>
            <a:gdLst>
              <a:gd name="T0" fmla="*/ 0 w 3447"/>
              <a:gd name="T1" fmla="*/ 0 h 932"/>
              <a:gd name="T2" fmla="*/ 0 w 3447"/>
              <a:gd name="T3" fmla="*/ 466 h 932"/>
              <a:gd name="T4" fmla="*/ 0 w 3447"/>
              <a:gd name="T5" fmla="*/ 932 h 932"/>
              <a:gd name="T6" fmla="*/ 421 w 3447"/>
              <a:gd name="T7" fmla="*/ 932 h 932"/>
              <a:gd name="T8" fmla="*/ 421 w 3447"/>
              <a:gd name="T9" fmla="*/ 622 h 932"/>
              <a:gd name="T10" fmla="*/ 3447 w 3447"/>
              <a:gd name="T11" fmla="*/ 622 h 932"/>
              <a:gd name="T12" fmla="*/ 3447 w 3447"/>
              <a:gd name="T13" fmla="*/ 0 h 932"/>
              <a:gd name="T14" fmla="*/ 0 w 3447"/>
              <a:gd name="T15" fmla="*/ 0 h 9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3447" h="932">
                <a:moveTo>
                  <a:pt x="0" y="0"/>
                </a:moveTo>
                <a:lnTo>
                  <a:pt x="0" y="466"/>
                </a:lnTo>
                <a:lnTo>
                  <a:pt x="0" y="932"/>
                </a:lnTo>
                <a:lnTo>
                  <a:pt x="421" y="932"/>
                </a:lnTo>
                <a:lnTo>
                  <a:pt x="421" y="622"/>
                </a:lnTo>
                <a:lnTo>
                  <a:pt x="3447" y="622"/>
                </a:lnTo>
                <a:lnTo>
                  <a:pt x="3447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29" name="Freeform 26"/>
          <p:cNvSpPr>
            <a:spLocks/>
          </p:cNvSpPr>
          <p:nvPr/>
        </p:nvSpPr>
        <p:spPr bwMode="auto">
          <a:xfrm>
            <a:off x="7053263" y="2489200"/>
            <a:ext cx="1585913" cy="236538"/>
          </a:xfrm>
          <a:custGeom>
            <a:avLst/>
            <a:gdLst>
              <a:gd name="T0" fmla="*/ 0 w 5547"/>
              <a:gd name="T1" fmla="*/ 0 h 622"/>
              <a:gd name="T2" fmla="*/ 0 w 5547"/>
              <a:gd name="T3" fmla="*/ 311 h 622"/>
              <a:gd name="T4" fmla="*/ 0 w 5547"/>
              <a:gd name="T5" fmla="*/ 622 h 622"/>
              <a:gd name="T6" fmla="*/ 5547 w 5547"/>
              <a:gd name="T7" fmla="*/ 622 h 622"/>
              <a:gd name="T8" fmla="*/ 5547 w 5547"/>
              <a:gd name="T9" fmla="*/ 0 h 622"/>
              <a:gd name="T10" fmla="*/ 0 w 5547"/>
              <a:gd name="T11" fmla="*/ 0 h 6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5547" h="622">
                <a:moveTo>
                  <a:pt x="0" y="0"/>
                </a:moveTo>
                <a:lnTo>
                  <a:pt x="0" y="311"/>
                </a:lnTo>
                <a:lnTo>
                  <a:pt x="0" y="622"/>
                </a:lnTo>
                <a:lnTo>
                  <a:pt x="5547" y="622"/>
                </a:lnTo>
                <a:lnTo>
                  <a:pt x="5547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30" name="Freeform 27"/>
          <p:cNvSpPr>
            <a:spLocks/>
          </p:cNvSpPr>
          <p:nvPr/>
        </p:nvSpPr>
        <p:spPr bwMode="auto">
          <a:xfrm>
            <a:off x="6453188" y="3673475"/>
            <a:ext cx="2185988" cy="238125"/>
          </a:xfrm>
          <a:custGeom>
            <a:avLst/>
            <a:gdLst>
              <a:gd name="T0" fmla="*/ 0 w 7641"/>
              <a:gd name="T1" fmla="*/ 0 h 621"/>
              <a:gd name="T2" fmla="*/ 0 w 7641"/>
              <a:gd name="T3" fmla="*/ 310 h 621"/>
              <a:gd name="T4" fmla="*/ 0 w 7641"/>
              <a:gd name="T5" fmla="*/ 621 h 621"/>
              <a:gd name="T6" fmla="*/ 7641 w 7641"/>
              <a:gd name="T7" fmla="*/ 621 h 621"/>
              <a:gd name="T8" fmla="*/ 7641 w 7641"/>
              <a:gd name="T9" fmla="*/ 0 h 621"/>
              <a:gd name="T10" fmla="*/ 0 w 7641"/>
              <a:gd name="T11" fmla="*/ 0 h 62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7641" h="621">
                <a:moveTo>
                  <a:pt x="0" y="0"/>
                </a:moveTo>
                <a:lnTo>
                  <a:pt x="0" y="310"/>
                </a:lnTo>
                <a:lnTo>
                  <a:pt x="0" y="621"/>
                </a:lnTo>
                <a:lnTo>
                  <a:pt x="7641" y="621"/>
                </a:lnTo>
                <a:lnTo>
                  <a:pt x="7641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31" name="Freeform 28"/>
          <p:cNvSpPr>
            <a:spLocks/>
          </p:cNvSpPr>
          <p:nvPr/>
        </p:nvSpPr>
        <p:spPr bwMode="auto">
          <a:xfrm>
            <a:off x="7335838" y="4859338"/>
            <a:ext cx="1303338" cy="236538"/>
          </a:xfrm>
          <a:custGeom>
            <a:avLst/>
            <a:gdLst>
              <a:gd name="T0" fmla="*/ 0 w 4554"/>
              <a:gd name="T1" fmla="*/ 0 h 622"/>
              <a:gd name="T2" fmla="*/ 0 w 4554"/>
              <a:gd name="T3" fmla="*/ 311 h 622"/>
              <a:gd name="T4" fmla="*/ 0 w 4554"/>
              <a:gd name="T5" fmla="*/ 622 h 622"/>
              <a:gd name="T6" fmla="*/ 4554 w 4554"/>
              <a:gd name="T7" fmla="*/ 622 h 622"/>
              <a:gd name="T8" fmla="*/ 4554 w 4554"/>
              <a:gd name="T9" fmla="*/ 0 h 622"/>
              <a:gd name="T10" fmla="*/ 0 w 4554"/>
              <a:gd name="T11" fmla="*/ 0 h 6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4554" h="622">
                <a:moveTo>
                  <a:pt x="0" y="0"/>
                </a:moveTo>
                <a:lnTo>
                  <a:pt x="0" y="311"/>
                </a:lnTo>
                <a:lnTo>
                  <a:pt x="0" y="622"/>
                </a:lnTo>
                <a:lnTo>
                  <a:pt x="4554" y="622"/>
                </a:lnTo>
                <a:lnTo>
                  <a:pt x="4554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32" name="Freeform 29"/>
          <p:cNvSpPr>
            <a:spLocks/>
          </p:cNvSpPr>
          <p:nvPr/>
        </p:nvSpPr>
        <p:spPr bwMode="auto">
          <a:xfrm>
            <a:off x="252413" y="119063"/>
            <a:ext cx="8386763" cy="3121025"/>
          </a:xfrm>
          <a:custGeom>
            <a:avLst/>
            <a:gdLst>
              <a:gd name="T0" fmla="*/ 0 w 29326"/>
              <a:gd name="T1" fmla="*/ 0 h 8184"/>
              <a:gd name="T2" fmla="*/ 0 w 29326"/>
              <a:gd name="T3" fmla="*/ 4092 h 8184"/>
              <a:gd name="T4" fmla="*/ 0 w 29326"/>
              <a:gd name="T5" fmla="*/ 8184 h 8184"/>
              <a:gd name="T6" fmla="*/ 19169 w 29326"/>
              <a:gd name="T7" fmla="*/ 8184 h 8184"/>
              <a:gd name="T8" fmla="*/ 19169 w 29326"/>
              <a:gd name="T9" fmla="*/ 5124 h 8184"/>
              <a:gd name="T10" fmla="*/ 20009 w 29326"/>
              <a:gd name="T11" fmla="*/ 5124 h 8184"/>
              <a:gd name="T12" fmla="*/ 20009 w 29326"/>
              <a:gd name="T13" fmla="*/ 2481 h 8184"/>
              <a:gd name="T14" fmla="*/ 21422 w 29326"/>
              <a:gd name="T15" fmla="*/ 2481 h 8184"/>
              <a:gd name="T16" fmla="*/ 21422 w 29326"/>
              <a:gd name="T17" fmla="*/ 1087 h 8184"/>
              <a:gd name="T18" fmla="*/ 22639 w 29326"/>
              <a:gd name="T19" fmla="*/ 1087 h 8184"/>
              <a:gd name="T20" fmla="*/ 22639 w 29326"/>
              <a:gd name="T21" fmla="*/ 621 h 8184"/>
              <a:gd name="T22" fmla="*/ 29326 w 29326"/>
              <a:gd name="T23" fmla="*/ 621 h 8184"/>
              <a:gd name="T24" fmla="*/ 29326 w 29326"/>
              <a:gd name="T25" fmla="*/ 0 h 8184"/>
              <a:gd name="T26" fmla="*/ 0 w 29326"/>
              <a:gd name="T27" fmla="*/ 0 h 8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  <a:cxn ang="0">
                <a:pos x="T16" y="T17"/>
              </a:cxn>
              <a:cxn ang="0">
                <a:pos x="T18" y="T19"/>
              </a:cxn>
              <a:cxn ang="0">
                <a:pos x="T20" y="T21"/>
              </a:cxn>
              <a:cxn ang="0">
                <a:pos x="T22" y="T23"/>
              </a:cxn>
              <a:cxn ang="0">
                <a:pos x="T24" y="T25"/>
              </a:cxn>
              <a:cxn ang="0">
                <a:pos x="T26" y="T27"/>
              </a:cxn>
            </a:cxnLst>
            <a:rect l="0" t="0" r="r" b="b"/>
            <a:pathLst>
              <a:path w="29326" h="8184">
                <a:moveTo>
                  <a:pt x="0" y="0"/>
                </a:moveTo>
                <a:lnTo>
                  <a:pt x="0" y="4092"/>
                </a:lnTo>
                <a:lnTo>
                  <a:pt x="0" y="8184"/>
                </a:lnTo>
                <a:lnTo>
                  <a:pt x="19169" y="8184"/>
                </a:lnTo>
                <a:lnTo>
                  <a:pt x="19169" y="5124"/>
                </a:lnTo>
                <a:lnTo>
                  <a:pt x="20009" y="5124"/>
                </a:lnTo>
                <a:lnTo>
                  <a:pt x="20009" y="2481"/>
                </a:lnTo>
                <a:lnTo>
                  <a:pt x="21422" y="2481"/>
                </a:lnTo>
                <a:lnTo>
                  <a:pt x="21422" y="1087"/>
                </a:lnTo>
                <a:lnTo>
                  <a:pt x="22639" y="1087"/>
                </a:lnTo>
                <a:lnTo>
                  <a:pt x="22639" y="621"/>
                </a:lnTo>
                <a:lnTo>
                  <a:pt x="29326" y="621"/>
                </a:lnTo>
                <a:lnTo>
                  <a:pt x="29326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33" name="Freeform 30"/>
          <p:cNvSpPr>
            <a:spLocks/>
          </p:cNvSpPr>
          <p:nvPr/>
        </p:nvSpPr>
        <p:spPr bwMode="auto">
          <a:xfrm>
            <a:off x="8027988" y="2962275"/>
            <a:ext cx="611188" cy="238125"/>
          </a:xfrm>
          <a:custGeom>
            <a:avLst/>
            <a:gdLst>
              <a:gd name="T0" fmla="*/ 0 w 2136"/>
              <a:gd name="T1" fmla="*/ 0 h 622"/>
              <a:gd name="T2" fmla="*/ 0 w 2136"/>
              <a:gd name="T3" fmla="*/ 311 h 622"/>
              <a:gd name="T4" fmla="*/ 0 w 2136"/>
              <a:gd name="T5" fmla="*/ 622 h 622"/>
              <a:gd name="T6" fmla="*/ 2136 w 2136"/>
              <a:gd name="T7" fmla="*/ 622 h 622"/>
              <a:gd name="T8" fmla="*/ 2136 w 2136"/>
              <a:gd name="T9" fmla="*/ 0 h 622"/>
              <a:gd name="T10" fmla="*/ 0 w 2136"/>
              <a:gd name="T11" fmla="*/ 0 h 62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</a:cxnLst>
            <a:rect l="0" t="0" r="r" b="b"/>
            <a:pathLst>
              <a:path w="2136" h="622">
                <a:moveTo>
                  <a:pt x="0" y="0"/>
                </a:moveTo>
                <a:lnTo>
                  <a:pt x="0" y="311"/>
                </a:lnTo>
                <a:lnTo>
                  <a:pt x="0" y="622"/>
                </a:lnTo>
                <a:lnTo>
                  <a:pt x="2136" y="622"/>
                </a:lnTo>
                <a:lnTo>
                  <a:pt x="2136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34" name="Freeform 31"/>
          <p:cNvSpPr>
            <a:spLocks/>
          </p:cNvSpPr>
          <p:nvPr/>
        </p:nvSpPr>
        <p:spPr bwMode="auto">
          <a:xfrm>
            <a:off x="8594726" y="1539875"/>
            <a:ext cx="44450" cy="355600"/>
          </a:xfrm>
          <a:custGeom>
            <a:avLst/>
            <a:gdLst>
              <a:gd name="T0" fmla="*/ 0 w 155"/>
              <a:gd name="T1" fmla="*/ 0 h 933"/>
              <a:gd name="T2" fmla="*/ 0 w 155"/>
              <a:gd name="T3" fmla="*/ 467 h 933"/>
              <a:gd name="T4" fmla="*/ 0 w 155"/>
              <a:gd name="T5" fmla="*/ 933 h 933"/>
              <a:gd name="T6" fmla="*/ 18 w 155"/>
              <a:gd name="T7" fmla="*/ 933 h 933"/>
              <a:gd name="T8" fmla="*/ 18 w 155"/>
              <a:gd name="T9" fmla="*/ 622 h 933"/>
              <a:gd name="T10" fmla="*/ 155 w 155"/>
              <a:gd name="T11" fmla="*/ 622 h 933"/>
              <a:gd name="T12" fmla="*/ 155 w 155"/>
              <a:gd name="T13" fmla="*/ 0 h 933"/>
              <a:gd name="T14" fmla="*/ 0 w 155"/>
              <a:gd name="T15" fmla="*/ 0 h 9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155" h="933">
                <a:moveTo>
                  <a:pt x="0" y="0"/>
                </a:moveTo>
                <a:lnTo>
                  <a:pt x="0" y="467"/>
                </a:lnTo>
                <a:lnTo>
                  <a:pt x="0" y="933"/>
                </a:lnTo>
                <a:lnTo>
                  <a:pt x="18" y="933"/>
                </a:lnTo>
                <a:lnTo>
                  <a:pt x="18" y="622"/>
                </a:lnTo>
                <a:lnTo>
                  <a:pt x="155" y="622"/>
                </a:lnTo>
                <a:lnTo>
                  <a:pt x="155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35" name="Freeform 32"/>
          <p:cNvSpPr>
            <a:spLocks/>
          </p:cNvSpPr>
          <p:nvPr/>
        </p:nvSpPr>
        <p:spPr bwMode="auto">
          <a:xfrm>
            <a:off x="7289801" y="6045200"/>
            <a:ext cx="1349375" cy="355600"/>
          </a:xfrm>
          <a:custGeom>
            <a:avLst/>
            <a:gdLst>
              <a:gd name="T0" fmla="*/ 0 w 4718"/>
              <a:gd name="T1" fmla="*/ 0 h 932"/>
              <a:gd name="T2" fmla="*/ 0 w 4718"/>
              <a:gd name="T3" fmla="*/ 466 h 932"/>
              <a:gd name="T4" fmla="*/ 0 w 4718"/>
              <a:gd name="T5" fmla="*/ 932 h 932"/>
              <a:gd name="T6" fmla="*/ 166 w 4718"/>
              <a:gd name="T7" fmla="*/ 932 h 932"/>
              <a:gd name="T8" fmla="*/ 166 w 4718"/>
              <a:gd name="T9" fmla="*/ 621 h 932"/>
              <a:gd name="T10" fmla="*/ 4718 w 4718"/>
              <a:gd name="T11" fmla="*/ 621 h 932"/>
              <a:gd name="T12" fmla="*/ 4718 w 4718"/>
              <a:gd name="T13" fmla="*/ 0 h 932"/>
              <a:gd name="T14" fmla="*/ 0 w 4718"/>
              <a:gd name="T15" fmla="*/ 0 h 9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4718" h="932">
                <a:moveTo>
                  <a:pt x="0" y="0"/>
                </a:moveTo>
                <a:lnTo>
                  <a:pt x="0" y="466"/>
                </a:lnTo>
                <a:lnTo>
                  <a:pt x="0" y="932"/>
                </a:lnTo>
                <a:lnTo>
                  <a:pt x="166" y="932"/>
                </a:lnTo>
                <a:lnTo>
                  <a:pt x="166" y="621"/>
                </a:lnTo>
                <a:lnTo>
                  <a:pt x="4718" y="621"/>
                </a:lnTo>
                <a:lnTo>
                  <a:pt x="4718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36" name="Freeform 33"/>
          <p:cNvSpPr>
            <a:spLocks/>
          </p:cNvSpPr>
          <p:nvPr/>
        </p:nvSpPr>
        <p:spPr bwMode="auto">
          <a:xfrm>
            <a:off x="6726238" y="355600"/>
            <a:ext cx="1912938" cy="355600"/>
          </a:xfrm>
          <a:custGeom>
            <a:avLst/>
            <a:gdLst>
              <a:gd name="T0" fmla="*/ 0 w 6687"/>
              <a:gd name="T1" fmla="*/ 0 h 932"/>
              <a:gd name="T2" fmla="*/ 0 w 6687"/>
              <a:gd name="T3" fmla="*/ 466 h 932"/>
              <a:gd name="T4" fmla="*/ 0 w 6687"/>
              <a:gd name="T5" fmla="*/ 932 h 932"/>
              <a:gd name="T6" fmla="*/ 744 w 6687"/>
              <a:gd name="T7" fmla="*/ 932 h 932"/>
              <a:gd name="T8" fmla="*/ 744 w 6687"/>
              <a:gd name="T9" fmla="*/ 621 h 932"/>
              <a:gd name="T10" fmla="*/ 6687 w 6687"/>
              <a:gd name="T11" fmla="*/ 621 h 932"/>
              <a:gd name="T12" fmla="*/ 6687 w 6687"/>
              <a:gd name="T13" fmla="*/ 0 h 932"/>
              <a:gd name="T14" fmla="*/ 0 w 6687"/>
              <a:gd name="T15" fmla="*/ 0 h 9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  <a:cxn ang="0">
                <a:pos x="T10" y="T11"/>
              </a:cxn>
              <a:cxn ang="0">
                <a:pos x="T12" y="T13"/>
              </a:cxn>
              <a:cxn ang="0">
                <a:pos x="T14" y="T15"/>
              </a:cxn>
            </a:cxnLst>
            <a:rect l="0" t="0" r="r" b="b"/>
            <a:pathLst>
              <a:path w="6687" h="932">
                <a:moveTo>
                  <a:pt x="0" y="0"/>
                </a:moveTo>
                <a:lnTo>
                  <a:pt x="0" y="466"/>
                </a:lnTo>
                <a:lnTo>
                  <a:pt x="0" y="932"/>
                </a:lnTo>
                <a:lnTo>
                  <a:pt x="744" y="932"/>
                </a:lnTo>
                <a:lnTo>
                  <a:pt x="744" y="621"/>
                </a:lnTo>
                <a:lnTo>
                  <a:pt x="6687" y="621"/>
                </a:lnTo>
                <a:lnTo>
                  <a:pt x="6687" y="0"/>
                </a:lnTo>
                <a:lnTo>
                  <a:pt x="0" y="0"/>
                </a:lnTo>
                <a:close/>
              </a:path>
            </a:pathLst>
          </a:custGeom>
          <a:noFill/>
          <a:ln w="6350" cap="sq">
            <a:solidFill>
              <a:srgbClr val="FFFFFF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37" name="Freeform 34"/>
          <p:cNvSpPr>
            <a:spLocks/>
          </p:cNvSpPr>
          <p:nvPr/>
        </p:nvSpPr>
        <p:spPr bwMode="auto">
          <a:xfrm>
            <a:off x="7289801" y="6045200"/>
            <a:ext cx="111125" cy="177800"/>
          </a:xfrm>
          <a:custGeom>
            <a:avLst/>
            <a:gdLst>
              <a:gd name="T0" fmla="*/ 391 w 391"/>
              <a:gd name="T1" fmla="*/ 0 h 466"/>
              <a:gd name="T2" fmla="*/ 0 w 391"/>
              <a:gd name="T3" fmla="*/ 0 h 466"/>
              <a:gd name="T4" fmla="*/ 0 w 391"/>
              <a:gd name="T5" fmla="*/ 466 h 4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91" h="466">
                <a:moveTo>
                  <a:pt x="391" y="0"/>
                </a:moveTo>
                <a:lnTo>
                  <a:pt x="0" y="0"/>
                </a:lnTo>
                <a:lnTo>
                  <a:pt x="0" y="466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38" name="Freeform 35"/>
          <p:cNvSpPr>
            <a:spLocks/>
          </p:cNvSpPr>
          <p:nvPr/>
        </p:nvSpPr>
        <p:spPr bwMode="auto">
          <a:xfrm>
            <a:off x="8599488" y="1778000"/>
            <a:ext cx="39688" cy="117475"/>
          </a:xfrm>
          <a:custGeom>
            <a:avLst/>
            <a:gdLst>
              <a:gd name="T0" fmla="*/ 137 w 137"/>
              <a:gd name="T1" fmla="*/ 0 h 311"/>
              <a:gd name="T2" fmla="*/ 0 w 137"/>
              <a:gd name="T3" fmla="*/ 0 h 311"/>
              <a:gd name="T4" fmla="*/ 0 w 137"/>
              <a:gd name="T5" fmla="*/ 311 h 3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7" h="311">
                <a:moveTo>
                  <a:pt x="137" y="0"/>
                </a:moveTo>
                <a:lnTo>
                  <a:pt x="0" y="0"/>
                </a:lnTo>
                <a:lnTo>
                  <a:pt x="0" y="311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39" name="Freeform 36"/>
          <p:cNvSpPr>
            <a:spLocks/>
          </p:cNvSpPr>
          <p:nvPr/>
        </p:nvSpPr>
        <p:spPr bwMode="auto">
          <a:xfrm>
            <a:off x="6691313" y="5200650"/>
            <a:ext cx="420688" cy="665163"/>
          </a:xfrm>
          <a:custGeom>
            <a:avLst/>
            <a:gdLst>
              <a:gd name="T0" fmla="*/ 1471 w 1471"/>
              <a:gd name="T1" fmla="*/ 1747 h 1747"/>
              <a:gd name="T2" fmla="*/ 0 w 1471"/>
              <a:gd name="T3" fmla="*/ 1747 h 1747"/>
              <a:gd name="T4" fmla="*/ 0 w 1471"/>
              <a:gd name="T5" fmla="*/ 0 h 17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71" h="1747">
                <a:moveTo>
                  <a:pt x="1471" y="1747"/>
                </a:moveTo>
                <a:lnTo>
                  <a:pt x="0" y="1747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40" name="Freeform 37"/>
          <p:cNvSpPr>
            <a:spLocks/>
          </p:cNvSpPr>
          <p:nvPr/>
        </p:nvSpPr>
        <p:spPr bwMode="auto">
          <a:xfrm>
            <a:off x="7053263" y="2489200"/>
            <a:ext cx="1125538" cy="117475"/>
          </a:xfrm>
          <a:custGeom>
            <a:avLst/>
            <a:gdLst>
              <a:gd name="T0" fmla="*/ 3937 w 3937"/>
              <a:gd name="T1" fmla="*/ 0 h 311"/>
              <a:gd name="T2" fmla="*/ 0 w 3937"/>
              <a:gd name="T3" fmla="*/ 0 h 311"/>
              <a:gd name="T4" fmla="*/ 0 w 3937"/>
              <a:gd name="T5" fmla="*/ 311 h 3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937" h="311">
                <a:moveTo>
                  <a:pt x="3937" y="0"/>
                </a:moveTo>
                <a:lnTo>
                  <a:pt x="0" y="0"/>
                </a:lnTo>
                <a:lnTo>
                  <a:pt x="0" y="311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41" name="Freeform 38"/>
          <p:cNvSpPr>
            <a:spLocks/>
          </p:cNvSpPr>
          <p:nvPr/>
        </p:nvSpPr>
        <p:spPr bwMode="auto">
          <a:xfrm>
            <a:off x="6378576" y="1065213"/>
            <a:ext cx="212725" cy="530225"/>
          </a:xfrm>
          <a:custGeom>
            <a:avLst/>
            <a:gdLst>
              <a:gd name="T0" fmla="*/ 746 w 746"/>
              <a:gd name="T1" fmla="*/ 1393 h 1393"/>
              <a:gd name="T2" fmla="*/ 0 w 746"/>
              <a:gd name="T3" fmla="*/ 1393 h 1393"/>
              <a:gd name="T4" fmla="*/ 0 w 746"/>
              <a:gd name="T5" fmla="*/ 0 h 13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46" h="1393">
                <a:moveTo>
                  <a:pt x="746" y="1393"/>
                </a:moveTo>
                <a:lnTo>
                  <a:pt x="0" y="1393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42" name="Freeform 39"/>
          <p:cNvSpPr>
            <a:spLocks/>
          </p:cNvSpPr>
          <p:nvPr/>
        </p:nvSpPr>
        <p:spPr bwMode="auto">
          <a:xfrm>
            <a:off x="6726238" y="355600"/>
            <a:ext cx="1158875" cy="177800"/>
          </a:xfrm>
          <a:custGeom>
            <a:avLst/>
            <a:gdLst>
              <a:gd name="T0" fmla="*/ 4051 w 4051"/>
              <a:gd name="T1" fmla="*/ 0 h 466"/>
              <a:gd name="T2" fmla="*/ 0 w 4051"/>
              <a:gd name="T3" fmla="*/ 0 h 466"/>
              <a:gd name="T4" fmla="*/ 0 w 4051"/>
              <a:gd name="T5" fmla="*/ 466 h 4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051" h="466">
                <a:moveTo>
                  <a:pt x="4051" y="0"/>
                </a:moveTo>
                <a:lnTo>
                  <a:pt x="0" y="0"/>
                </a:lnTo>
                <a:lnTo>
                  <a:pt x="0" y="466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43" name="Freeform 40"/>
          <p:cNvSpPr>
            <a:spLocks/>
          </p:cNvSpPr>
          <p:nvPr/>
        </p:nvSpPr>
        <p:spPr bwMode="auto">
          <a:xfrm>
            <a:off x="6591301" y="1595438"/>
            <a:ext cx="207963" cy="530225"/>
          </a:xfrm>
          <a:custGeom>
            <a:avLst/>
            <a:gdLst>
              <a:gd name="T0" fmla="*/ 725 w 725"/>
              <a:gd name="T1" fmla="*/ 1389 h 1389"/>
              <a:gd name="T2" fmla="*/ 0 w 725"/>
              <a:gd name="T3" fmla="*/ 1389 h 1389"/>
              <a:gd name="T4" fmla="*/ 0 w 725"/>
              <a:gd name="T5" fmla="*/ 0 h 13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25" h="1389">
                <a:moveTo>
                  <a:pt x="725" y="1389"/>
                </a:moveTo>
                <a:lnTo>
                  <a:pt x="0" y="1389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44" name="Freeform 41"/>
          <p:cNvSpPr>
            <a:spLocks/>
          </p:cNvSpPr>
          <p:nvPr/>
        </p:nvSpPr>
        <p:spPr bwMode="auto">
          <a:xfrm>
            <a:off x="5972176" y="3614738"/>
            <a:ext cx="180975" cy="792163"/>
          </a:xfrm>
          <a:custGeom>
            <a:avLst/>
            <a:gdLst>
              <a:gd name="T0" fmla="*/ 631 w 631"/>
              <a:gd name="T1" fmla="*/ 0 h 2078"/>
              <a:gd name="T2" fmla="*/ 0 w 631"/>
              <a:gd name="T3" fmla="*/ 0 h 2078"/>
              <a:gd name="T4" fmla="*/ 0 w 631"/>
              <a:gd name="T5" fmla="*/ 2078 h 20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31" h="2078">
                <a:moveTo>
                  <a:pt x="631" y="0"/>
                </a:moveTo>
                <a:lnTo>
                  <a:pt x="0" y="0"/>
                </a:lnTo>
                <a:lnTo>
                  <a:pt x="0" y="2078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45" name="Freeform 42"/>
          <p:cNvSpPr>
            <a:spLocks/>
          </p:cNvSpPr>
          <p:nvPr/>
        </p:nvSpPr>
        <p:spPr bwMode="auto">
          <a:xfrm>
            <a:off x="7335838" y="4859338"/>
            <a:ext cx="30163" cy="119063"/>
          </a:xfrm>
          <a:custGeom>
            <a:avLst/>
            <a:gdLst>
              <a:gd name="T0" fmla="*/ 105 w 105"/>
              <a:gd name="T1" fmla="*/ 0 h 311"/>
              <a:gd name="T2" fmla="*/ 0 w 105"/>
              <a:gd name="T3" fmla="*/ 0 h 311"/>
              <a:gd name="T4" fmla="*/ 0 w 105"/>
              <a:gd name="T5" fmla="*/ 311 h 3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5" h="311">
                <a:moveTo>
                  <a:pt x="105" y="0"/>
                </a:moveTo>
                <a:lnTo>
                  <a:pt x="0" y="0"/>
                </a:lnTo>
                <a:lnTo>
                  <a:pt x="0" y="311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46" name="Freeform 43"/>
          <p:cNvSpPr>
            <a:spLocks/>
          </p:cNvSpPr>
          <p:nvPr/>
        </p:nvSpPr>
        <p:spPr bwMode="auto">
          <a:xfrm>
            <a:off x="7340601" y="4148138"/>
            <a:ext cx="82550" cy="119063"/>
          </a:xfrm>
          <a:custGeom>
            <a:avLst/>
            <a:gdLst>
              <a:gd name="T0" fmla="*/ 290 w 290"/>
              <a:gd name="T1" fmla="*/ 0 h 310"/>
              <a:gd name="T2" fmla="*/ 0 w 290"/>
              <a:gd name="T3" fmla="*/ 0 h 310"/>
              <a:gd name="T4" fmla="*/ 0 w 290"/>
              <a:gd name="T5" fmla="*/ 310 h 3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0" h="310">
                <a:moveTo>
                  <a:pt x="290" y="0"/>
                </a:moveTo>
                <a:lnTo>
                  <a:pt x="0" y="0"/>
                </a:lnTo>
                <a:lnTo>
                  <a:pt x="0" y="31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47" name="Freeform 44"/>
          <p:cNvSpPr>
            <a:spLocks/>
          </p:cNvSpPr>
          <p:nvPr/>
        </p:nvSpPr>
        <p:spPr bwMode="auto">
          <a:xfrm>
            <a:off x="6691313" y="4533900"/>
            <a:ext cx="544513" cy="666750"/>
          </a:xfrm>
          <a:custGeom>
            <a:avLst/>
            <a:gdLst>
              <a:gd name="T0" fmla="*/ 1907 w 1907"/>
              <a:gd name="T1" fmla="*/ 0 h 1748"/>
              <a:gd name="T2" fmla="*/ 0 w 1907"/>
              <a:gd name="T3" fmla="*/ 0 h 1748"/>
              <a:gd name="T4" fmla="*/ 0 w 1907"/>
              <a:gd name="T5" fmla="*/ 1748 h 174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07" h="1748">
                <a:moveTo>
                  <a:pt x="1907" y="0"/>
                </a:moveTo>
                <a:lnTo>
                  <a:pt x="0" y="0"/>
                </a:lnTo>
                <a:lnTo>
                  <a:pt x="0" y="1748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48" name="Freeform 45"/>
          <p:cNvSpPr>
            <a:spLocks/>
          </p:cNvSpPr>
          <p:nvPr/>
        </p:nvSpPr>
        <p:spPr bwMode="auto">
          <a:xfrm>
            <a:off x="252413" y="1679575"/>
            <a:ext cx="5481638" cy="1560513"/>
          </a:xfrm>
          <a:custGeom>
            <a:avLst/>
            <a:gdLst>
              <a:gd name="T0" fmla="*/ 19169 w 19169"/>
              <a:gd name="T1" fmla="*/ 4092 h 4092"/>
              <a:gd name="T2" fmla="*/ 0 w 19169"/>
              <a:gd name="T3" fmla="*/ 4092 h 4092"/>
              <a:gd name="T4" fmla="*/ 0 w 19169"/>
              <a:gd name="T5" fmla="*/ 0 h 40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169" h="4092">
                <a:moveTo>
                  <a:pt x="19169" y="4092"/>
                </a:moveTo>
                <a:lnTo>
                  <a:pt x="0" y="4092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49" name="Freeform 46"/>
          <p:cNvSpPr>
            <a:spLocks/>
          </p:cNvSpPr>
          <p:nvPr/>
        </p:nvSpPr>
        <p:spPr bwMode="auto">
          <a:xfrm>
            <a:off x="6591301" y="1066800"/>
            <a:ext cx="1577975" cy="528638"/>
          </a:xfrm>
          <a:custGeom>
            <a:avLst/>
            <a:gdLst>
              <a:gd name="T0" fmla="*/ 5519 w 5519"/>
              <a:gd name="T1" fmla="*/ 0 h 1389"/>
              <a:gd name="T2" fmla="*/ 0 w 5519"/>
              <a:gd name="T3" fmla="*/ 0 h 1389"/>
              <a:gd name="T4" fmla="*/ 0 w 5519"/>
              <a:gd name="T5" fmla="*/ 1389 h 13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519" h="1389">
                <a:moveTo>
                  <a:pt x="5519" y="0"/>
                </a:moveTo>
                <a:lnTo>
                  <a:pt x="0" y="0"/>
                </a:lnTo>
                <a:lnTo>
                  <a:pt x="0" y="1389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50" name="Freeform 47"/>
          <p:cNvSpPr>
            <a:spLocks/>
          </p:cNvSpPr>
          <p:nvPr/>
        </p:nvSpPr>
        <p:spPr bwMode="auto">
          <a:xfrm>
            <a:off x="7653338" y="5334000"/>
            <a:ext cx="141288" cy="177800"/>
          </a:xfrm>
          <a:custGeom>
            <a:avLst/>
            <a:gdLst>
              <a:gd name="T0" fmla="*/ 493 w 493"/>
              <a:gd name="T1" fmla="*/ 0 h 466"/>
              <a:gd name="T2" fmla="*/ 0 w 493"/>
              <a:gd name="T3" fmla="*/ 0 h 466"/>
              <a:gd name="T4" fmla="*/ 0 w 493"/>
              <a:gd name="T5" fmla="*/ 466 h 4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3" h="466">
                <a:moveTo>
                  <a:pt x="493" y="0"/>
                </a:moveTo>
                <a:lnTo>
                  <a:pt x="0" y="0"/>
                </a:lnTo>
                <a:lnTo>
                  <a:pt x="0" y="466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51" name="Freeform 48"/>
          <p:cNvSpPr>
            <a:spLocks/>
          </p:cNvSpPr>
          <p:nvPr/>
        </p:nvSpPr>
        <p:spPr bwMode="auto">
          <a:xfrm>
            <a:off x="8027988" y="3081338"/>
            <a:ext cx="127000" cy="119063"/>
          </a:xfrm>
          <a:custGeom>
            <a:avLst/>
            <a:gdLst>
              <a:gd name="T0" fmla="*/ 445 w 445"/>
              <a:gd name="T1" fmla="*/ 311 h 311"/>
              <a:gd name="T2" fmla="*/ 0 w 445"/>
              <a:gd name="T3" fmla="*/ 311 h 311"/>
              <a:gd name="T4" fmla="*/ 0 w 445"/>
              <a:gd name="T5" fmla="*/ 0 h 3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45" h="311">
                <a:moveTo>
                  <a:pt x="445" y="311"/>
                </a:moveTo>
                <a:lnTo>
                  <a:pt x="0" y="311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52" name="Freeform 49"/>
          <p:cNvSpPr>
            <a:spLocks/>
          </p:cNvSpPr>
          <p:nvPr/>
        </p:nvSpPr>
        <p:spPr bwMode="auto">
          <a:xfrm>
            <a:off x="7053263" y="2606675"/>
            <a:ext cx="1495425" cy="119063"/>
          </a:xfrm>
          <a:custGeom>
            <a:avLst/>
            <a:gdLst>
              <a:gd name="T0" fmla="*/ 5235 w 5235"/>
              <a:gd name="T1" fmla="*/ 311 h 311"/>
              <a:gd name="T2" fmla="*/ 0 w 5235"/>
              <a:gd name="T3" fmla="*/ 311 h 311"/>
              <a:gd name="T4" fmla="*/ 0 w 5235"/>
              <a:gd name="T5" fmla="*/ 0 h 3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235" h="311">
                <a:moveTo>
                  <a:pt x="5235" y="311"/>
                </a:moveTo>
                <a:lnTo>
                  <a:pt x="0" y="311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53" name="Freeform 50"/>
          <p:cNvSpPr>
            <a:spLocks/>
          </p:cNvSpPr>
          <p:nvPr/>
        </p:nvSpPr>
        <p:spPr bwMode="auto">
          <a:xfrm>
            <a:off x="6938963" y="592138"/>
            <a:ext cx="479425" cy="119063"/>
          </a:xfrm>
          <a:custGeom>
            <a:avLst/>
            <a:gdLst>
              <a:gd name="T0" fmla="*/ 1674 w 1674"/>
              <a:gd name="T1" fmla="*/ 0 h 311"/>
              <a:gd name="T2" fmla="*/ 0 w 1674"/>
              <a:gd name="T3" fmla="*/ 0 h 311"/>
              <a:gd name="T4" fmla="*/ 0 w 1674"/>
              <a:gd name="T5" fmla="*/ 311 h 3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74" h="311">
                <a:moveTo>
                  <a:pt x="1674" y="0"/>
                </a:moveTo>
                <a:lnTo>
                  <a:pt x="0" y="0"/>
                </a:lnTo>
                <a:lnTo>
                  <a:pt x="0" y="311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54" name="Freeform 51"/>
          <p:cNvSpPr>
            <a:spLocks/>
          </p:cNvSpPr>
          <p:nvPr/>
        </p:nvSpPr>
        <p:spPr bwMode="auto">
          <a:xfrm>
            <a:off x="8599488" y="1895475"/>
            <a:ext cx="0" cy="119063"/>
          </a:xfrm>
          <a:custGeom>
            <a:avLst/>
            <a:gdLst>
              <a:gd name="T0" fmla="*/ 310 h 310"/>
              <a:gd name="T1" fmla="*/ 310 h 310"/>
              <a:gd name="T2" fmla="*/ 0 h 31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310">
                <a:moveTo>
                  <a:pt x="0" y="310"/>
                </a:moveTo>
                <a:lnTo>
                  <a:pt x="0" y="310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55" name="Freeform 52"/>
          <p:cNvSpPr>
            <a:spLocks/>
          </p:cNvSpPr>
          <p:nvPr/>
        </p:nvSpPr>
        <p:spPr bwMode="auto">
          <a:xfrm>
            <a:off x="7289801" y="6223000"/>
            <a:ext cx="47625" cy="177800"/>
          </a:xfrm>
          <a:custGeom>
            <a:avLst/>
            <a:gdLst>
              <a:gd name="T0" fmla="*/ 166 w 166"/>
              <a:gd name="T1" fmla="*/ 466 h 466"/>
              <a:gd name="T2" fmla="*/ 0 w 166"/>
              <a:gd name="T3" fmla="*/ 466 h 466"/>
              <a:gd name="T4" fmla="*/ 0 w 166"/>
              <a:gd name="T5" fmla="*/ 0 h 4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6" h="466">
                <a:moveTo>
                  <a:pt x="166" y="466"/>
                </a:moveTo>
                <a:lnTo>
                  <a:pt x="0" y="466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56" name="Freeform 53"/>
          <p:cNvSpPr>
            <a:spLocks/>
          </p:cNvSpPr>
          <p:nvPr/>
        </p:nvSpPr>
        <p:spPr bwMode="auto">
          <a:xfrm>
            <a:off x="7340601" y="4267200"/>
            <a:ext cx="104775" cy="117475"/>
          </a:xfrm>
          <a:custGeom>
            <a:avLst/>
            <a:gdLst>
              <a:gd name="T0" fmla="*/ 366 w 366"/>
              <a:gd name="T1" fmla="*/ 311 h 311"/>
              <a:gd name="T2" fmla="*/ 0 w 366"/>
              <a:gd name="T3" fmla="*/ 311 h 311"/>
              <a:gd name="T4" fmla="*/ 0 w 366"/>
              <a:gd name="T5" fmla="*/ 0 h 3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6" h="311">
                <a:moveTo>
                  <a:pt x="366" y="311"/>
                </a:moveTo>
                <a:lnTo>
                  <a:pt x="0" y="311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57" name="Freeform 54"/>
          <p:cNvSpPr>
            <a:spLocks/>
          </p:cNvSpPr>
          <p:nvPr/>
        </p:nvSpPr>
        <p:spPr bwMode="auto">
          <a:xfrm>
            <a:off x="6153151" y="3436938"/>
            <a:ext cx="1122363" cy="177800"/>
          </a:xfrm>
          <a:custGeom>
            <a:avLst/>
            <a:gdLst>
              <a:gd name="T0" fmla="*/ 3928 w 3928"/>
              <a:gd name="T1" fmla="*/ 0 h 466"/>
              <a:gd name="T2" fmla="*/ 0 w 3928"/>
              <a:gd name="T3" fmla="*/ 0 h 466"/>
              <a:gd name="T4" fmla="*/ 0 w 3928"/>
              <a:gd name="T5" fmla="*/ 466 h 4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928" h="466">
                <a:moveTo>
                  <a:pt x="3928" y="0"/>
                </a:moveTo>
                <a:lnTo>
                  <a:pt x="0" y="0"/>
                </a:lnTo>
                <a:lnTo>
                  <a:pt x="0" y="466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58" name="Freeform 55"/>
          <p:cNvSpPr>
            <a:spLocks/>
          </p:cNvSpPr>
          <p:nvPr/>
        </p:nvSpPr>
        <p:spPr bwMode="auto">
          <a:xfrm>
            <a:off x="7112001" y="5511800"/>
            <a:ext cx="541338" cy="354013"/>
          </a:xfrm>
          <a:custGeom>
            <a:avLst/>
            <a:gdLst>
              <a:gd name="T0" fmla="*/ 1894 w 1894"/>
              <a:gd name="T1" fmla="*/ 0 h 932"/>
              <a:gd name="T2" fmla="*/ 0 w 1894"/>
              <a:gd name="T3" fmla="*/ 0 h 932"/>
              <a:gd name="T4" fmla="*/ 0 w 1894"/>
              <a:gd name="T5" fmla="*/ 932 h 9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94" h="932">
                <a:moveTo>
                  <a:pt x="1894" y="0"/>
                </a:moveTo>
                <a:lnTo>
                  <a:pt x="0" y="0"/>
                </a:lnTo>
                <a:lnTo>
                  <a:pt x="0" y="932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59" name="Freeform 56"/>
          <p:cNvSpPr>
            <a:spLocks/>
          </p:cNvSpPr>
          <p:nvPr/>
        </p:nvSpPr>
        <p:spPr bwMode="auto">
          <a:xfrm>
            <a:off x="7337426" y="6400800"/>
            <a:ext cx="30163" cy="117475"/>
          </a:xfrm>
          <a:custGeom>
            <a:avLst/>
            <a:gdLst>
              <a:gd name="T0" fmla="*/ 106 w 106"/>
              <a:gd name="T1" fmla="*/ 311 h 311"/>
              <a:gd name="T2" fmla="*/ 0 w 106"/>
              <a:gd name="T3" fmla="*/ 311 h 311"/>
              <a:gd name="T4" fmla="*/ 0 w 106"/>
              <a:gd name="T5" fmla="*/ 0 h 3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6" h="311">
                <a:moveTo>
                  <a:pt x="106" y="311"/>
                </a:moveTo>
                <a:lnTo>
                  <a:pt x="0" y="311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60" name="Freeform 57"/>
          <p:cNvSpPr>
            <a:spLocks/>
          </p:cNvSpPr>
          <p:nvPr/>
        </p:nvSpPr>
        <p:spPr bwMode="auto">
          <a:xfrm>
            <a:off x="6799263" y="2125663"/>
            <a:ext cx="254000" cy="481013"/>
          </a:xfrm>
          <a:custGeom>
            <a:avLst/>
            <a:gdLst>
              <a:gd name="T0" fmla="*/ 886 w 886"/>
              <a:gd name="T1" fmla="*/ 1262 h 1262"/>
              <a:gd name="T2" fmla="*/ 0 w 886"/>
              <a:gd name="T3" fmla="*/ 1262 h 1262"/>
              <a:gd name="T4" fmla="*/ 0 w 886"/>
              <a:gd name="T5" fmla="*/ 0 h 126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86" h="1262">
                <a:moveTo>
                  <a:pt x="886" y="1262"/>
                </a:moveTo>
                <a:lnTo>
                  <a:pt x="0" y="1262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61" name="Freeform 58"/>
          <p:cNvSpPr>
            <a:spLocks/>
          </p:cNvSpPr>
          <p:nvPr/>
        </p:nvSpPr>
        <p:spPr bwMode="auto">
          <a:xfrm>
            <a:off x="6153151" y="3614738"/>
            <a:ext cx="300038" cy="177800"/>
          </a:xfrm>
          <a:custGeom>
            <a:avLst/>
            <a:gdLst>
              <a:gd name="T0" fmla="*/ 1053 w 1053"/>
              <a:gd name="T1" fmla="*/ 466 h 466"/>
              <a:gd name="T2" fmla="*/ 0 w 1053"/>
              <a:gd name="T3" fmla="*/ 466 h 466"/>
              <a:gd name="T4" fmla="*/ 0 w 1053"/>
              <a:gd name="T5" fmla="*/ 0 h 4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53" h="466">
                <a:moveTo>
                  <a:pt x="1053" y="466"/>
                </a:moveTo>
                <a:lnTo>
                  <a:pt x="0" y="466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62" name="Freeform 59"/>
          <p:cNvSpPr>
            <a:spLocks/>
          </p:cNvSpPr>
          <p:nvPr/>
        </p:nvSpPr>
        <p:spPr bwMode="auto">
          <a:xfrm>
            <a:off x="7315201" y="4800600"/>
            <a:ext cx="20638" cy="177800"/>
          </a:xfrm>
          <a:custGeom>
            <a:avLst/>
            <a:gdLst>
              <a:gd name="T0" fmla="*/ 75 w 75"/>
              <a:gd name="T1" fmla="*/ 466 h 466"/>
              <a:gd name="T2" fmla="*/ 0 w 75"/>
              <a:gd name="T3" fmla="*/ 466 h 466"/>
              <a:gd name="T4" fmla="*/ 0 w 75"/>
              <a:gd name="T5" fmla="*/ 0 h 4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5" h="466">
                <a:moveTo>
                  <a:pt x="75" y="466"/>
                </a:moveTo>
                <a:lnTo>
                  <a:pt x="0" y="466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63" name="Freeform 60"/>
          <p:cNvSpPr>
            <a:spLocks/>
          </p:cNvSpPr>
          <p:nvPr/>
        </p:nvSpPr>
        <p:spPr bwMode="auto">
          <a:xfrm>
            <a:off x="8583613" y="1717675"/>
            <a:ext cx="11113" cy="266700"/>
          </a:xfrm>
          <a:custGeom>
            <a:avLst/>
            <a:gdLst>
              <a:gd name="T0" fmla="*/ 35 w 35"/>
              <a:gd name="T1" fmla="*/ 0 h 699"/>
              <a:gd name="T2" fmla="*/ 0 w 35"/>
              <a:gd name="T3" fmla="*/ 0 h 699"/>
              <a:gd name="T4" fmla="*/ 0 w 35"/>
              <a:gd name="T5" fmla="*/ 699 h 69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5" h="699">
                <a:moveTo>
                  <a:pt x="35" y="0"/>
                </a:moveTo>
                <a:lnTo>
                  <a:pt x="0" y="0"/>
                </a:lnTo>
                <a:lnTo>
                  <a:pt x="0" y="699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64" name="Freeform 61"/>
          <p:cNvSpPr>
            <a:spLocks/>
          </p:cNvSpPr>
          <p:nvPr/>
        </p:nvSpPr>
        <p:spPr bwMode="auto">
          <a:xfrm>
            <a:off x="6938963" y="711200"/>
            <a:ext cx="1247775" cy="117475"/>
          </a:xfrm>
          <a:custGeom>
            <a:avLst/>
            <a:gdLst>
              <a:gd name="T0" fmla="*/ 4364 w 4364"/>
              <a:gd name="T1" fmla="*/ 311 h 311"/>
              <a:gd name="T2" fmla="*/ 0 w 4364"/>
              <a:gd name="T3" fmla="*/ 311 h 311"/>
              <a:gd name="T4" fmla="*/ 0 w 4364"/>
              <a:gd name="T5" fmla="*/ 0 h 3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64" h="311">
                <a:moveTo>
                  <a:pt x="4364" y="311"/>
                </a:moveTo>
                <a:lnTo>
                  <a:pt x="0" y="311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65" name="Freeform 62"/>
          <p:cNvSpPr>
            <a:spLocks/>
          </p:cNvSpPr>
          <p:nvPr/>
        </p:nvSpPr>
        <p:spPr bwMode="auto">
          <a:xfrm>
            <a:off x="6378576" y="533400"/>
            <a:ext cx="347663" cy="531813"/>
          </a:xfrm>
          <a:custGeom>
            <a:avLst/>
            <a:gdLst>
              <a:gd name="T0" fmla="*/ 1217 w 1217"/>
              <a:gd name="T1" fmla="*/ 0 h 1394"/>
              <a:gd name="T2" fmla="*/ 0 w 1217"/>
              <a:gd name="T3" fmla="*/ 0 h 1394"/>
              <a:gd name="T4" fmla="*/ 0 w 1217"/>
              <a:gd name="T5" fmla="*/ 1394 h 139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17" h="1394">
                <a:moveTo>
                  <a:pt x="1217" y="0"/>
                </a:moveTo>
                <a:lnTo>
                  <a:pt x="0" y="0"/>
                </a:lnTo>
                <a:lnTo>
                  <a:pt x="0" y="1394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66" name="Freeform 63"/>
          <p:cNvSpPr>
            <a:spLocks/>
          </p:cNvSpPr>
          <p:nvPr/>
        </p:nvSpPr>
        <p:spPr bwMode="auto">
          <a:xfrm>
            <a:off x="5734051" y="2073275"/>
            <a:ext cx="239713" cy="1166813"/>
          </a:xfrm>
          <a:custGeom>
            <a:avLst/>
            <a:gdLst>
              <a:gd name="T0" fmla="*/ 840 w 840"/>
              <a:gd name="T1" fmla="*/ 0 h 3060"/>
              <a:gd name="T2" fmla="*/ 0 w 840"/>
              <a:gd name="T3" fmla="*/ 0 h 3060"/>
              <a:gd name="T4" fmla="*/ 0 w 840"/>
              <a:gd name="T5" fmla="*/ 3060 h 30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40" h="3060">
                <a:moveTo>
                  <a:pt x="840" y="0"/>
                </a:moveTo>
                <a:lnTo>
                  <a:pt x="0" y="0"/>
                </a:lnTo>
                <a:lnTo>
                  <a:pt x="0" y="306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67" name="Freeform 64"/>
          <p:cNvSpPr>
            <a:spLocks/>
          </p:cNvSpPr>
          <p:nvPr/>
        </p:nvSpPr>
        <p:spPr bwMode="auto">
          <a:xfrm>
            <a:off x="5973763" y="1065213"/>
            <a:ext cx="404813" cy="1008063"/>
          </a:xfrm>
          <a:custGeom>
            <a:avLst/>
            <a:gdLst>
              <a:gd name="T0" fmla="*/ 1413 w 1413"/>
              <a:gd name="T1" fmla="*/ 0 h 2643"/>
              <a:gd name="T2" fmla="*/ 0 w 1413"/>
              <a:gd name="T3" fmla="*/ 0 h 2643"/>
              <a:gd name="T4" fmla="*/ 0 w 1413"/>
              <a:gd name="T5" fmla="*/ 2643 h 264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13" h="2643">
                <a:moveTo>
                  <a:pt x="1413" y="0"/>
                </a:moveTo>
                <a:lnTo>
                  <a:pt x="0" y="0"/>
                </a:lnTo>
                <a:lnTo>
                  <a:pt x="0" y="2643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68" name="Freeform 65"/>
          <p:cNvSpPr>
            <a:spLocks/>
          </p:cNvSpPr>
          <p:nvPr/>
        </p:nvSpPr>
        <p:spPr bwMode="auto">
          <a:xfrm>
            <a:off x="8594726" y="1717675"/>
            <a:ext cx="4763" cy="177800"/>
          </a:xfrm>
          <a:custGeom>
            <a:avLst/>
            <a:gdLst>
              <a:gd name="T0" fmla="*/ 18 w 18"/>
              <a:gd name="T1" fmla="*/ 466 h 466"/>
              <a:gd name="T2" fmla="*/ 0 w 18"/>
              <a:gd name="T3" fmla="*/ 466 h 466"/>
              <a:gd name="T4" fmla="*/ 0 w 18"/>
              <a:gd name="T5" fmla="*/ 0 h 4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" h="466">
                <a:moveTo>
                  <a:pt x="18" y="466"/>
                </a:moveTo>
                <a:lnTo>
                  <a:pt x="0" y="466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69" name="Freeform 66"/>
          <p:cNvSpPr>
            <a:spLocks/>
          </p:cNvSpPr>
          <p:nvPr/>
        </p:nvSpPr>
        <p:spPr bwMode="auto">
          <a:xfrm>
            <a:off x="8583613" y="1984375"/>
            <a:ext cx="20638" cy="266700"/>
          </a:xfrm>
          <a:custGeom>
            <a:avLst/>
            <a:gdLst>
              <a:gd name="T0" fmla="*/ 69 w 69"/>
              <a:gd name="T1" fmla="*/ 699 h 699"/>
              <a:gd name="T2" fmla="*/ 0 w 69"/>
              <a:gd name="T3" fmla="*/ 699 h 699"/>
              <a:gd name="T4" fmla="*/ 0 w 69"/>
              <a:gd name="T5" fmla="*/ 0 h 69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9" h="699">
                <a:moveTo>
                  <a:pt x="69" y="699"/>
                </a:moveTo>
                <a:lnTo>
                  <a:pt x="0" y="699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70" name="Freeform 67"/>
          <p:cNvSpPr>
            <a:spLocks/>
          </p:cNvSpPr>
          <p:nvPr/>
        </p:nvSpPr>
        <p:spPr bwMode="auto">
          <a:xfrm>
            <a:off x="7337426" y="6281738"/>
            <a:ext cx="66675" cy="119063"/>
          </a:xfrm>
          <a:custGeom>
            <a:avLst/>
            <a:gdLst>
              <a:gd name="T0" fmla="*/ 235 w 235"/>
              <a:gd name="T1" fmla="*/ 0 h 311"/>
              <a:gd name="T2" fmla="*/ 0 w 235"/>
              <a:gd name="T3" fmla="*/ 0 h 311"/>
              <a:gd name="T4" fmla="*/ 0 w 235"/>
              <a:gd name="T5" fmla="*/ 311 h 3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35" h="311">
                <a:moveTo>
                  <a:pt x="235" y="0"/>
                </a:moveTo>
                <a:lnTo>
                  <a:pt x="0" y="0"/>
                </a:lnTo>
                <a:lnTo>
                  <a:pt x="0" y="311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71" name="Freeform 68"/>
          <p:cNvSpPr>
            <a:spLocks/>
          </p:cNvSpPr>
          <p:nvPr/>
        </p:nvSpPr>
        <p:spPr bwMode="auto">
          <a:xfrm>
            <a:off x="5734051" y="3240088"/>
            <a:ext cx="238125" cy="1166813"/>
          </a:xfrm>
          <a:custGeom>
            <a:avLst/>
            <a:gdLst>
              <a:gd name="T0" fmla="*/ 832 w 832"/>
              <a:gd name="T1" fmla="*/ 3060 h 3060"/>
              <a:gd name="T2" fmla="*/ 0 w 832"/>
              <a:gd name="T3" fmla="*/ 3060 h 3060"/>
              <a:gd name="T4" fmla="*/ 0 w 832"/>
              <a:gd name="T5" fmla="*/ 0 h 30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32" h="3060">
                <a:moveTo>
                  <a:pt x="832" y="3060"/>
                </a:moveTo>
                <a:lnTo>
                  <a:pt x="0" y="3060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72" name="Freeform 69"/>
          <p:cNvSpPr>
            <a:spLocks/>
          </p:cNvSpPr>
          <p:nvPr/>
        </p:nvSpPr>
        <p:spPr bwMode="auto">
          <a:xfrm>
            <a:off x="7235826" y="4533900"/>
            <a:ext cx="79375" cy="266700"/>
          </a:xfrm>
          <a:custGeom>
            <a:avLst/>
            <a:gdLst>
              <a:gd name="T0" fmla="*/ 276 w 276"/>
              <a:gd name="T1" fmla="*/ 699 h 699"/>
              <a:gd name="T2" fmla="*/ 0 w 276"/>
              <a:gd name="T3" fmla="*/ 699 h 699"/>
              <a:gd name="T4" fmla="*/ 0 w 276"/>
              <a:gd name="T5" fmla="*/ 0 h 69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6" h="699">
                <a:moveTo>
                  <a:pt x="276" y="699"/>
                </a:moveTo>
                <a:lnTo>
                  <a:pt x="0" y="699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73" name="Freeform 70"/>
          <p:cNvSpPr>
            <a:spLocks/>
          </p:cNvSpPr>
          <p:nvPr/>
        </p:nvSpPr>
        <p:spPr bwMode="auto">
          <a:xfrm>
            <a:off x="7315201" y="4622800"/>
            <a:ext cx="122238" cy="177800"/>
          </a:xfrm>
          <a:custGeom>
            <a:avLst/>
            <a:gdLst>
              <a:gd name="T0" fmla="*/ 430 w 430"/>
              <a:gd name="T1" fmla="*/ 0 h 466"/>
              <a:gd name="T2" fmla="*/ 0 w 430"/>
              <a:gd name="T3" fmla="*/ 0 h 466"/>
              <a:gd name="T4" fmla="*/ 0 w 430"/>
              <a:gd name="T5" fmla="*/ 466 h 4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0" h="466">
                <a:moveTo>
                  <a:pt x="430" y="0"/>
                </a:moveTo>
                <a:lnTo>
                  <a:pt x="0" y="0"/>
                </a:lnTo>
                <a:lnTo>
                  <a:pt x="0" y="466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74" name="Freeform 71"/>
          <p:cNvSpPr>
            <a:spLocks/>
          </p:cNvSpPr>
          <p:nvPr/>
        </p:nvSpPr>
        <p:spPr bwMode="auto">
          <a:xfrm>
            <a:off x="252413" y="119063"/>
            <a:ext cx="4194175" cy="1560513"/>
          </a:xfrm>
          <a:custGeom>
            <a:avLst/>
            <a:gdLst>
              <a:gd name="T0" fmla="*/ 14663 w 14663"/>
              <a:gd name="T1" fmla="*/ 0 h 4092"/>
              <a:gd name="T2" fmla="*/ 0 w 14663"/>
              <a:gd name="T3" fmla="*/ 0 h 4092"/>
              <a:gd name="T4" fmla="*/ 0 w 14663"/>
              <a:gd name="T5" fmla="*/ 4092 h 409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4663" h="4092">
                <a:moveTo>
                  <a:pt x="14663" y="0"/>
                </a:moveTo>
                <a:lnTo>
                  <a:pt x="0" y="0"/>
                </a:lnTo>
                <a:lnTo>
                  <a:pt x="0" y="4092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75" name="Freeform 72"/>
          <p:cNvSpPr>
            <a:spLocks/>
          </p:cNvSpPr>
          <p:nvPr/>
        </p:nvSpPr>
        <p:spPr bwMode="auto">
          <a:xfrm>
            <a:off x="8027988" y="2962275"/>
            <a:ext cx="80963" cy="119063"/>
          </a:xfrm>
          <a:custGeom>
            <a:avLst/>
            <a:gdLst>
              <a:gd name="T0" fmla="*/ 281 w 281"/>
              <a:gd name="T1" fmla="*/ 0 h 311"/>
              <a:gd name="T2" fmla="*/ 0 w 281"/>
              <a:gd name="T3" fmla="*/ 0 h 311"/>
              <a:gd name="T4" fmla="*/ 0 w 281"/>
              <a:gd name="T5" fmla="*/ 311 h 3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81" h="311">
                <a:moveTo>
                  <a:pt x="281" y="0"/>
                </a:moveTo>
                <a:lnTo>
                  <a:pt x="0" y="0"/>
                </a:lnTo>
                <a:lnTo>
                  <a:pt x="0" y="311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76" name="Freeform 73"/>
          <p:cNvSpPr>
            <a:spLocks/>
          </p:cNvSpPr>
          <p:nvPr/>
        </p:nvSpPr>
        <p:spPr bwMode="auto">
          <a:xfrm>
            <a:off x="7335838" y="4978400"/>
            <a:ext cx="206375" cy="117475"/>
          </a:xfrm>
          <a:custGeom>
            <a:avLst/>
            <a:gdLst>
              <a:gd name="T0" fmla="*/ 722 w 722"/>
              <a:gd name="T1" fmla="*/ 311 h 311"/>
              <a:gd name="T2" fmla="*/ 0 w 722"/>
              <a:gd name="T3" fmla="*/ 311 h 311"/>
              <a:gd name="T4" fmla="*/ 0 w 722"/>
              <a:gd name="T5" fmla="*/ 0 h 3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22" h="311">
                <a:moveTo>
                  <a:pt x="722" y="311"/>
                </a:moveTo>
                <a:lnTo>
                  <a:pt x="0" y="311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77" name="Freeform 74"/>
          <p:cNvSpPr>
            <a:spLocks/>
          </p:cNvSpPr>
          <p:nvPr/>
        </p:nvSpPr>
        <p:spPr bwMode="auto">
          <a:xfrm>
            <a:off x="8415338" y="1644650"/>
            <a:ext cx="168275" cy="339725"/>
          </a:xfrm>
          <a:custGeom>
            <a:avLst/>
            <a:gdLst>
              <a:gd name="T0" fmla="*/ 593 w 593"/>
              <a:gd name="T1" fmla="*/ 894 h 894"/>
              <a:gd name="T2" fmla="*/ 0 w 593"/>
              <a:gd name="T3" fmla="*/ 894 h 894"/>
              <a:gd name="T4" fmla="*/ 0 w 593"/>
              <a:gd name="T5" fmla="*/ 0 h 89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93" h="894">
                <a:moveTo>
                  <a:pt x="593" y="894"/>
                </a:moveTo>
                <a:lnTo>
                  <a:pt x="0" y="894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78" name="Freeform 75"/>
          <p:cNvSpPr>
            <a:spLocks/>
          </p:cNvSpPr>
          <p:nvPr/>
        </p:nvSpPr>
        <p:spPr bwMode="auto">
          <a:xfrm>
            <a:off x="6799263" y="1644650"/>
            <a:ext cx="1616075" cy="481013"/>
          </a:xfrm>
          <a:custGeom>
            <a:avLst/>
            <a:gdLst>
              <a:gd name="T0" fmla="*/ 5650 w 5650"/>
              <a:gd name="T1" fmla="*/ 0 h 1263"/>
              <a:gd name="T2" fmla="*/ 0 w 5650"/>
              <a:gd name="T3" fmla="*/ 0 h 1263"/>
              <a:gd name="T4" fmla="*/ 0 w 5650"/>
              <a:gd name="T5" fmla="*/ 1263 h 126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650" h="1263">
                <a:moveTo>
                  <a:pt x="5650" y="0"/>
                </a:moveTo>
                <a:lnTo>
                  <a:pt x="0" y="0"/>
                </a:lnTo>
                <a:lnTo>
                  <a:pt x="0" y="1263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79" name="Freeform 76"/>
          <p:cNvSpPr>
            <a:spLocks/>
          </p:cNvSpPr>
          <p:nvPr/>
        </p:nvSpPr>
        <p:spPr bwMode="auto">
          <a:xfrm>
            <a:off x="7653338" y="5511800"/>
            <a:ext cx="120650" cy="177800"/>
          </a:xfrm>
          <a:custGeom>
            <a:avLst/>
            <a:gdLst>
              <a:gd name="T0" fmla="*/ 421 w 421"/>
              <a:gd name="T1" fmla="*/ 466 h 466"/>
              <a:gd name="T2" fmla="*/ 0 w 421"/>
              <a:gd name="T3" fmla="*/ 466 h 466"/>
              <a:gd name="T4" fmla="*/ 0 w 421"/>
              <a:gd name="T5" fmla="*/ 0 h 4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21" h="466">
                <a:moveTo>
                  <a:pt x="421" y="466"/>
                </a:moveTo>
                <a:lnTo>
                  <a:pt x="0" y="466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80" name="Freeform 77"/>
          <p:cNvSpPr>
            <a:spLocks/>
          </p:cNvSpPr>
          <p:nvPr/>
        </p:nvSpPr>
        <p:spPr bwMode="auto">
          <a:xfrm>
            <a:off x="5972176" y="4406900"/>
            <a:ext cx="719138" cy="793750"/>
          </a:xfrm>
          <a:custGeom>
            <a:avLst/>
            <a:gdLst>
              <a:gd name="T0" fmla="*/ 2513 w 2513"/>
              <a:gd name="T1" fmla="*/ 2079 h 2079"/>
              <a:gd name="T2" fmla="*/ 0 w 2513"/>
              <a:gd name="T3" fmla="*/ 2079 h 2079"/>
              <a:gd name="T4" fmla="*/ 0 w 2513"/>
              <a:gd name="T5" fmla="*/ 0 h 20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13" h="2079">
                <a:moveTo>
                  <a:pt x="2513" y="2079"/>
                </a:moveTo>
                <a:lnTo>
                  <a:pt x="0" y="2079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81" name="Freeform 78"/>
          <p:cNvSpPr>
            <a:spLocks/>
          </p:cNvSpPr>
          <p:nvPr/>
        </p:nvSpPr>
        <p:spPr bwMode="auto">
          <a:xfrm>
            <a:off x="7773988" y="5570538"/>
            <a:ext cx="6350" cy="119063"/>
          </a:xfrm>
          <a:custGeom>
            <a:avLst/>
            <a:gdLst>
              <a:gd name="T0" fmla="*/ 23 w 23"/>
              <a:gd name="T1" fmla="*/ 0 h 310"/>
              <a:gd name="T2" fmla="*/ 0 w 23"/>
              <a:gd name="T3" fmla="*/ 0 h 310"/>
              <a:gd name="T4" fmla="*/ 0 w 23"/>
              <a:gd name="T5" fmla="*/ 310 h 3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3" h="310">
                <a:moveTo>
                  <a:pt x="23" y="0"/>
                </a:moveTo>
                <a:lnTo>
                  <a:pt x="0" y="0"/>
                </a:lnTo>
                <a:lnTo>
                  <a:pt x="0" y="31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82" name="Freeform 79"/>
          <p:cNvSpPr>
            <a:spLocks/>
          </p:cNvSpPr>
          <p:nvPr/>
        </p:nvSpPr>
        <p:spPr bwMode="auto">
          <a:xfrm>
            <a:off x="6453188" y="3673475"/>
            <a:ext cx="990600" cy="119063"/>
          </a:xfrm>
          <a:custGeom>
            <a:avLst/>
            <a:gdLst>
              <a:gd name="T0" fmla="*/ 3465 w 3465"/>
              <a:gd name="T1" fmla="*/ 0 h 310"/>
              <a:gd name="T2" fmla="*/ 0 w 3465"/>
              <a:gd name="T3" fmla="*/ 0 h 310"/>
              <a:gd name="T4" fmla="*/ 0 w 3465"/>
              <a:gd name="T5" fmla="*/ 310 h 31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465" h="310">
                <a:moveTo>
                  <a:pt x="3465" y="0"/>
                </a:moveTo>
                <a:lnTo>
                  <a:pt x="0" y="0"/>
                </a:lnTo>
                <a:lnTo>
                  <a:pt x="0" y="31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83" name="Freeform 80"/>
          <p:cNvSpPr>
            <a:spLocks/>
          </p:cNvSpPr>
          <p:nvPr/>
        </p:nvSpPr>
        <p:spPr bwMode="auto">
          <a:xfrm>
            <a:off x="7235826" y="4267200"/>
            <a:ext cx="104775" cy="266700"/>
          </a:xfrm>
          <a:custGeom>
            <a:avLst/>
            <a:gdLst>
              <a:gd name="T0" fmla="*/ 365 w 365"/>
              <a:gd name="T1" fmla="*/ 0 h 700"/>
              <a:gd name="T2" fmla="*/ 0 w 365"/>
              <a:gd name="T3" fmla="*/ 0 h 700"/>
              <a:gd name="T4" fmla="*/ 0 w 365"/>
              <a:gd name="T5" fmla="*/ 700 h 7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5" h="700">
                <a:moveTo>
                  <a:pt x="365" y="0"/>
                </a:moveTo>
                <a:lnTo>
                  <a:pt x="0" y="0"/>
                </a:lnTo>
                <a:lnTo>
                  <a:pt x="0" y="70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84" name="Freeform 81"/>
          <p:cNvSpPr>
            <a:spLocks/>
          </p:cNvSpPr>
          <p:nvPr/>
        </p:nvSpPr>
        <p:spPr bwMode="auto">
          <a:xfrm>
            <a:off x="6726238" y="533400"/>
            <a:ext cx="212725" cy="177800"/>
          </a:xfrm>
          <a:custGeom>
            <a:avLst/>
            <a:gdLst>
              <a:gd name="T0" fmla="*/ 744 w 744"/>
              <a:gd name="T1" fmla="*/ 466 h 466"/>
              <a:gd name="T2" fmla="*/ 0 w 744"/>
              <a:gd name="T3" fmla="*/ 466 h 466"/>
              <a:gd name="T4" fmla="*/ 0 w 744"/>
              <a:gd name="T5" fmla="*/ 0 h 4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44" h="466">
                <a:moveTo>
                  <a:pt x="744" y="466"/>
                </a:moveTo>
                <a:lnTo>
                  <a:pt x="0" y="466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85" name="Freeform 82"/>
          <p:cNvSpPr>
            <a:spLocks/>
          </p:cNvSpPr>
          <p:nvPr/>
        </p:nvSpPr>
        <p:spPr bwMode="auto">
          <a:xfrm>
            <a:off x="8594726" y="1539875"/>
            <a:ext cx="7938" cy="177800"/>
          </a:xfrm>
          <a:custGeom>
            <a:avLst/>
            <a:gdLst>
              <a:gd name="T0" fmla="*/ 32 w 32"/>
              <a:gd name="T1" fmla="*/ 0 h 467"/>
              <a:gd name="T2" fmla="*/ 0 w 32"/>
              <a:gd name="T3" fmla="*/ 0 h 467"/>
              <a:gd name="T4" fmla="*/ 0 w 32"/>
              <a:gd name="T5" fmla="*/ 467 h 46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2" h="467">
                <a:moveTo>
                  <a:pt x="32" y="0"/>
                </a:moveTo>
                <a:lnTo>
                  <a:pt x="0" y="0"/>
                </a:lnTo>
                <a:lnTo>
                  <a:pt x="0" y="467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86" name="Freeform 83"/>
          <p:cNvSpPr>
            <a:spLocks/>
          </p:cNvSpPr>
          <p:nvPr/>
        </p:nvSpPr>
        <p:spPr bwMode="auto">
          <a:xfrm>
            <a:off x="8415338" y="1303338"/>
            <a:ext cx="84138" cy="341313"/>
          </a:xfrm>
          <a:custGeom>
            <a:avLst/>
            <a:gdLst>
              <a:gd name="T0" fmla="*/ 296 w 296"/>
              <a:gd name="T1" fmla="*/ 0 h 893"/>
              <a:gd name="T2" fmla="*/ 0 w 296"/>
              <a:gd name="T3" fmla="*/ 0 h 893"/>
              <a:gd name="T4" fmla="*/ 0 w 296"/>
              <a:gd name="T5" fmla="*/ 893 h 89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6" h="893">
                <a:moveTo>
                  <a:pt x="296" y="0"/>
                </a:moveTo>
                <a:lnTo>
                  <a:pt x="0" y="0"/>
                </a:lnTo>
                <a:lnTo>
                  <a:pt x="0" y="893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87" name="Line 84"/>
          <p:cNvSpPr>
            <a:spLocks noChangeShapeType="1"/>
          </p:cNvSpPr>
          <p:nvPr/>
        </p:nvSpPr>
        <p:spPr bwMode="auto">
          <a:xfrm>
            <a:off x="169863" y="1679575"/>
            <a:ext cx="82550" cy="0"/>
          </a:xfrm>
          <a:prstGeom prst="line">
            <a:avLst/>
          </a:pr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88" name="Freeform 85"/>
          <p:cNvSpPr>
            <a:spLocks/>
          </p:cNvSpPr>
          <p:nvPr/>
        </p:nvSpPr>
        <p:spPr bwMode="auto">
          <a:xfrm>
            <a:off x="6453188" y="3792538"/>
            <a:ext cx="1212850" cy="119063"/>
          </a:xfrm>
          <a:custGeom>
            <a:avLst/>
            <a:gdLst>
              <a:gd name="T0" fmla="*/ 4242 w 4242"/>
              <a:gd name="T1" fmla="*/ 311 h 311"/>
              <a:gd name="T2" fmla="*/ 0 w 4242"/>
              <a:gd name="T3" fmla="*/ 311 h 311"/>
              <a:gd name="T4" fmla="*/ 0 w 4242"/>
              <a:gd name="T5" fmla="*/ 0 h 3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242" h="311">
                <a:moveTo>
                  <a:pt x="4242" y="311"/>
                </a:moveTo>
                <a:lnTo>
                  <a:pt x="0" y="311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89" name="Freeform 86"/>
          <p:cNvSpPr>
            <a:spLocks/>
          </p:cNvSpPr>
          <p:nvPr/>
        </p:nvSpPr>
        <p:spPr bwMode="auto">
          <a:xfrm>
            <a:off x="7773988" y="5689600"/>
            <a:ext cx="20638" cy="117475"/>
          </a:xfrm>
          <a:custGeom>
            <a:avLst/>
            <a:gdLst>
              <a:gd name="T0" fmla="*/ 76 w 76"/>
              <a:gd name="T1" fmla="*/ 311 h 311"/>
              <a:gd name="T2" fmla="*/ 0 w 76"/>
              <a:gd name="T3" fmla="*/ 311 h 311"/>
              <a:gd name="T4" fmla="*/ 0 w 76"/>
              <a:gd name="T5" fmla="*/ 0 h 31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6" h="311">
                <a:moveTo>
                  <a:pt x="76" y="311"/>
                </a:moveTo>
                <a:lnTo>
                  <a:pt x="0" y="311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90" name="Freeform 87"/>
          <p:cNvSpPr>
            <a:spLocks/>
          </p:cNvSpPr>
          <p:nvPr/>
        </p:nvSpPr>
        <p:spPr bwMode="auto">
          <a:xfrm>
            <a:off x="5973763" y="2073275"/>
            <a:ext cx="2054225" cy="1008063"/>
          </a:xfrm>
          <a:custGeom>
            <a:avLst/>
            <a:gdLst>
              <a:gd name="T0" fmla="*/ 7181 w 7181"/>
              <a:gd name="T1" fmla="*/ 2644 h 2644"/>
              <a:gd name="T2" fmla="*/ 0 w 7181"/>
              <a:gd name="T3" fmla="*/ 2644 h 2644"/>
              <a:gd name="T4" fmla="*/ 0 w 7181"/>
              <a:gd name="T5" fmla="*/ 0 h 26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181" h="2644">
                <a:moveTo>
                  <a:pt x="7181" y="2644"/>
                </a:moveTo>
                <a:lnTo>
                  <a:pt x="0" y="2644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91" name="Freeform 88"/>
          <p:cNvSpPr>
            <a:spLocks/>
          </p:cNvSpPr>
          <p:nvPr/>
        </p:nvSpPr>
        <p:spPr bwMode="auto">
          <a:xfrm>
            <a:off x="7112001" y="5865813"/>
            <a:ext cx="177800" cy="357188"/>
          </a:xfrm>
          <a:custGeom>
            <a:avLst/>
            <a:gdLst>
              <a:gd name="T0" fmla="*/ 623 w 623"/>
              <a:gd name="T1" fmla="*/ 933 h 933"/>
              <a:gd name="T2" fmla="*/ 0 w 623"/>
              <a:gd name="T3" fmla="*/ 933 h 933"/>
              <a:gd name="T4" fmla="*/ 0 w 623"/>
              <a:gd name="T5" fmla="*/ 0 h 93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23" h="933">
                <a:moveTo>
                  <a:pt x="623" y="933"/>
                </a:moveTo>
                <a:lnTo>
                  <a:pt x="0" y="933"/>
                </a:lnTo>
                <a:lnTo>
                  <a:pt x="0" y="0"/>
                </a:lnTo>
              </a:path>
            </a:pathLst>
          </a:custGeom>
          <a:noFill/>
          <a:ln w="11113" cap="flat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fr-FR" sz="800"/>
          </a:p>
        </p:txBody>
      </p:sp>
      <p:sp>
        <p:nvSpPr>
          <p:cNvPr id="92" name="Rectangle 89"/>
          <p:cNvSpPr>
            <a:spLocks noChangeArrowheads="1"/>
          </p:cNvSpPr>
          <p:nvPr/>
        </p:nvSpPr>
        <p:spPr bwMode="auto">
          <a:xfrm>
            <a:off x="7429501" y="6011863"/>
            <a:ext cx="62837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p_Ap_J9K2G8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3" name="Rectangle 90"/>
          <p:cNvSpPr>
            <a:spLocks noChangeArrowheads="1"/>
          </p:cNvSpPr>
          <p:nvPr/>
        </p:nvSpPr>
        <p:spPr bwMode="auto">
          <a:xfrm>
            <a:off x="8667751" y="1744663"/>
            <a:ext cx="63158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p_Ap_J9LGC7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4" name="Rectangle 91"/>
          <p:cNvSpPr>
            <a:spLocks noChangeArrowheads="1"/>
          </p:cNvSpPr>
          <p:nvPr/>
        </p:nvSpPr>
        <p:spPr bwMode="auto">
          <a:xfrm>
            <a:off x="8632826" y="2219325"/>
            <a:ext cx="71974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p_Ap_X1WTM8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5" name="Rectangle 92"/>
          <p:cNvSpPr>
            <a:spLocks noChangeArrowheads="1"/>
          </p:cNvSpPr>
          <p:nvPr/>
        </p:nvSpPr>
        <p:spPr bwMode="auto">
          <a:xfrm>
            <a:off x="8207376" y="2455863"/>
            <a:ext cx="95378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m_Am_A0A088AEM1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6" name="Rectangle 93"/>
          <p:cNvSpPr>
            <a:spLocks noChangeArrowheads="1"/>
          </p:cNvSpPr>
          <p:nvPr/>
        </p:nvSpPr>
        <p:spPr bwMode="auto">
          <a:xfrm>
            <a:off x="7432676" y="6249988"/>
            <a:ext cx="61555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p_Ap_J9K6E7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7" name="Rectangle 94"/>
          <p:cNvSpPr>
            <a:spLocks noChangeArrowheads="1"/>
          </p:cNvSpPr>
          <p:nvPr/>
        </p:nvSpPr>
        <p:spPr bwMode="auto">
          <a:xfrm>
            <a:off x="7913688" y="320675"/>
            <a:ext cx="63639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Hs_Hs_Q7Z3Z4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8" name="Rectangle 95"/>
          <p:cNvSpPr>
            <a:spLocks noChangeArrowheads="1"/>
          </p:cNvSpPr>
          <p:nvPr/>
        </p:nvSpPr>
        <p:spPr bwMode="auto">
          <a:xfrm>
            <a:off x="7394576" y="4827588"/>
            <a:ext cx="60753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p_Ap_J9K701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99" name="Rectangle 96"/>
          <p:cNvSpPr>
            <a:spLocks noChangeArrowheads="1"/>
          </p:cNvSpPr>
          <p:nvPr/>
        </p:nvSpPr>
        <p:spPr bwMode="auto">
          <a:xfrm>
            <a:off x="7451726" y="4116388"/>
            <a:ext cx="64601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p_Ap_J9JWH1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0" name="Rectangle 97"/>
          <p:cNvSpPr>
            <a:spLocks noChangeArrowheads="1"/>
          </p:cNvSpPr>
          <p:nvPr/>
        </p:nvSpPr>
        <p:spPr bwMode="auto">
          <a:xfrm>
            <a:off x="7466013" y="4589463"/>
            <a:ext cx="60753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p_Ap_J9K744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1" name="Rectangle 98"/>
          <p:cNvSpPr>
            <a:spLocks noChangeArrowheads="1"/>
          </p:cNvSpPr>
          <p:nvPr/>
        </p:nvSpPr>
        <p:spPr bwMode="auto">
          <a:xfrm>
            <a:off x="4475163" y="85725"/>
            <a:ext cx="45365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Ce_O61931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2" name="Rectangle 99"/>
          <p:cNvSpPr>
            <a:spLocks noChangeArrowheads="1"/>
          </p:cNvSpPr>
          <p:nvPr/>
        </p:nvSpPr>
        <p:spPr bwMode="auto">
          <a:xfrm>
            <a:off x="8199438" y="1031875"/>
            <a:ext cx="64280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Hs_Hs_Q8TC59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3" name="Rectangle 100"/>
          <p:cNvSpPr>
            <a:spLocks noChangeArrowheads="1"/>
          </p:cNvSpPr>
          <p:nvPr/>
        </p:nvSpPr>
        <p:spPr bwMode="auto">
          <a:xfrm>
            <a:off x="8137526" y="2930525"/>
            <a:ext cx="60433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Ce_Ce_Q17567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4" name="Rectangle 101"/>
          <p:cNvSpPr>
            <a:spLocks noChangeArrowheads="1"/>
          </p:cNvSpPr>
          <p:nvPr/>
        </p:nvSpPr>
        <p:spPr bwMode="auto">
          <a:xfrm>
            <a:off x="7572376" y="5064125"/>
            <a:ext cx="62356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p_Ap_J9KX17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5" name="Rectangle 102"/>
          <p:cNvSpPr>
            <a:spLocks noChangeArrowheads="1"/>
          </p:cNvSpPr>
          <p:nvPr/>
        </p:nvSpPr>
        <p:spPr bwMode="auto">
          <a:xfrm>
            <a:off x="7823201" y="5300663"/>
            <a:ext cx="58509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p_Ap_J9JZ66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6" name="Rectangle 103"/>
          <p:cNvSpPr>
            <a:spLocks noChangeArrowheads="1"/>
          </p:cNvSpPr>
          <p:nvPr/>
        </p:nvSpPr>
        <p:spPr bwMode="auto">
          <a:xfrm>
            <a:off x="8183563" y="3167063"/>
            <a:ext cx="58669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Ce_Ce_P90786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7" name="Rectangle 104"/>
          <p:cNvSpPr>
            <a:spLocks noChangeArrowheads="1"/>
          </p:cNvSpPr>
          <p:nvPr/>
        </p:nvSpPr>
        <p:spPr bwMode="auto">
          <a:xfrm>
            <a:off x="8578851" y="2693988"/>
            <a:ext cx="72295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Dm_Dm_Q7PLK0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8" name="Rectangle 105"/>
          <p:cNvSpPr>
            <a:spLocks noChangeArrowheads="1"/>
          </p:cNvSpPr>
          <p:nvPr/>
        </p:nvSpPr>
        <p:spPr bwMode="auto">
          <a:xfrm>
            <a:off x="7446963" y="560388"/>
            <a:ext cx="59792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Hs_Hs_Q96J94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09" name="Rectangle 106"/>
          <p:cNvSpPr>
            <a:spLocks noChangeArrowheads="1"/>
          </p:cNvSpPr>
          <p:nvPr/>
        </p:nvSpPr>
        <p:spPr bwMode="auto">
          <a:xfrm>
            <a:off x="7808913" y="5538788"/>
            <a:ext cx="67807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p_Ap_X1WIQ7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0" name="Rectangle 107"/>
          <p:cNvSpPr>
            <a:spLocks noChangeArrowheads="1"/>
          </p:cNvSpPr>
          <p:nvPr/>
        </p:nvSpPr>
        <p:spPr bwMode="auto">
          <a:xfrm>
            <a:off x="8628063" y="1982788"/>
            <a:ext cx="69249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p_Ap_X1WN06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1" name="Rectangle 108"/>
          <p:cNvSpPr>
            <a:spLocks noChangeArrowheads="1"/>
          </p:cNvSpPr>
          <p:nvPr/>
        </p:nvSpPr>
        <p:spPr bwMode="auto">
          <a:xfrm>
            <a:off x="7473951" y="4352925"/>
            <a:ext cx="59792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p_Ap_J9JYB0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2" name="Rectangle 109"/>
          <p:cNvSpPr>
            <a:spLocks noChangeArrowheads="1"/>
          </p:cNvSpPr>
          <p:nvPr/>
        </p:nvSpPr>
        <p:spPr bwMode="auto">
          <a:xfrm>
            <a:off x="7473951" y="3641725"/>
            <a:ext cx="69410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Dm_Dm_O76922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3" name="Rectangle 110"/>
          <p:cNvSpPr>
            <a:spLocks noChangeArrowheads="1"/>
          </p:cNvSpPr>
          <p:nvPr/>
        </p:nvSpPr>
        <p:spPr bwMode="auto">
          <a:xfrm>
            <a:off x="7304088" y="3405188"/>
            <a:ext cx="93615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m_Am_A0A088ARC0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4" name="Rectangle 111"/>
          <p:cNvSpPr>
            <a:spLocks noChangeArrowheads="1"/>
          </p:cNvSpPr>
          <p:nvPr/>
        </p:nvSpPr>
        <p:spPr bwMode="auto">
          <a:xfrm>
            <a:off x="8632826" y="1508125"/>
            <a:ext cx="66204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p_Ap_X1X5U6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5" name="Rectangle 112"/>
          <p:cNvSpPr>
            <a:spLocks noChangeArrowheads="1"/>
          </p:cNvSpPr>
          <p:nvPr/>
        </p:nvSpPr>
        <p:spPr bwMode="auto">
          <a:xfrm>
            <a:off x="7396163" y="6486525"/>
            <a:ext cx="59792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p_Ap_J9JU50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6" name="Rectangle 113"/>
          <p:cNvSpPr>
            <a:spLocks noChangeArrowheads="1"/>
          </p:cNvSpPr>
          <p:nvPr/>
        </p:nvSpPr>
        <p:spPr bwMode="auto">
          <a:xfrm>
            <a:off x="8528051" y="1271588"/>
            <a:ext cx="61074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p_Ap_J9K5F3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7" name="Rectangle 114"/>
          <p:cNvSpPr>
            <a:spLocks noChangeArrowheads="1"/>
          </p:cNvSpPr>
          <p:nvPr/>
        </p:nvSpPr>
        <p:spPr bwMode="auto">
          <a:xfrm>
            <a:off x="7696201" y="3878263"/>
            <a:ext cx="77104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Dm_Dm_Q9VKM1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8" name="Rectangle 115"/>
          <p:cNvSpPr>
            <a:spLocks noChangeArrowheads="1"/>
          </p:cNvSpPr>
          <p:nvPr/>
        </p:nvSpPr>
        <p:spPr bwMode="auto">
          <a:xfrm>
            <a:off x="7823201" y="5775325"/>
            <a:ext cx="64601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Ap_Ap_J9KYN1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19" name="Rectangle 116"/>
          <p:cNvSpPr>
            <a:spLocks noChangeArrowheads="1"/>
          </p:cNvSpPr>
          <p:nvPr/>
        </p:nvSpPr>
        <p:spPr bwMode="auto">
          <a:xfrm>
            <a:off x="8215313" y="796925"/>
            <a:ext cx="63639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000000"/>
                </a:solidFill>
                <a:effectLst/>
                <a:latin typeface="Adobe Devanagari" panose="02040503050201020203" pitchFamily="18" charset="0"/>
              </a:rPr>
              <a:t>Hs_Hs_Q7Z3Z3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0" name="Rectangle 117"/>
          <p:cNvSpPr>
            <a:spLocks noChangeArrowheads="1"/>
          </p:cNvSpPr>
          <p:nvPr/>
        </p:nvSpPr>
        <p:spPr bwMode="auto">
          <a:xfrm>
            <a:off x="7140576" y="5834063"/>
            <a:ext cx="13946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CC52BB"/>
                </a:solidFill>
                <a:effectLst/>
                <a:latin typeface="Adobe Devanagari" panose="02040503050201020203" pitchFamily="18" charset="0"/>
              </a:rPr>
              <a:t>100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1" name="Rectangle 118"/>
          <p:cNvSpPr>
            <a:spLocks noChangeArrowheads="1"/>
          </p:cNvSpPr>
          <p:nvPr/>
        </p:nvSpPr>
        <p:spPr bwMode="auto">
          <a:xfrm>
            <a:off x="6003926" y="2041525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993D3D"/>
                </a:solidFill>
                <a:effectLst/>
                <a:latin typeface="Adobe Devanagari" panose="02040503050201020203" pitchFamily="18" charset="0"/>
              </a:rPr>
              <a:t>41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2" name="Rectangle 119"/>
          <p:cNvSpPr>
            <a:spLocks noChangeArrowheads="1"/>
          </p:cNvSpPr>
          <p:nvPr/>
        </p:nvSpPr>
        <p:spPr bwMode="auto">
          <a:xfrm>
            <a:off x="6407151" y="1031875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75CC52"/>
                </a:solidFill>
                <a:effectLst/>
                <a:latin typeface="Adobe Devanagari" panose="02040503050201020203" pitchFamily="18" charset="0"/>
              </a:rPr>
              <a:t>61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3" name="Rectangle 120"/>
          <p:cNvSpPr>
            <a:spLocks noChangeArrowheads="1"/>
          </p:cNvSpPr>
          <p:nvPr/>
        </p:nvSpPr>
        <p:spPr bwMode="auto">
          <a:xfrm>
            <a:off x="8628063" y="1863725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CC5252"/>
                </a:solidFill>
                <a:effectLst/>
                <a:latin typeface="Adobe Devanagari" panose="02040503050201020203" pitchFamily="18" charset="0"/>
              </a:rPr>
              <a:t>34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4" name="Rectangle 121"/>
          <p:cNvSpPr>
            <a:spLocks noChangeArrowheads="1"/>
          </p:cNvSpPr>
          <p:nvPr/>
        </p:nvSpPr>
        <p:spPr bwMode="auto">
          <a:xfrm>
            <a:off x="6619876" y="1563688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57993D"/>
                </a:solidFill>
                <a:effectLst/>
                <a:latin typeface="Adobe Devanagari" panose="02040503050201020203" pitchFamily="18" charset="0"/>
              </a:rPr>
              <a:t>62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5" name="Rectangle 122"/>
          <p:cNvSpPr>
            <a:spLocks noChangeArrowheads="1"/>
          </p:cNvSpPr>
          <p:nvPr/>
        </p:nvSpPr>
        <p:spPr bwMode="auto">
          <a:xfrm>
            <a:off x="6000751" y="4375150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3D9972"/>
                </a:solidFill>
                <a:effectLst/>
                <a:latin typeface="Adobe Devanagari" panose="02040503050201020203" pitchFamily="18" charset="0"/>
              </a:rPr>
              <a:t>76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6" name="Rectangle 123"/>
          <p:cNvSpPr>
            <a:spLocks noChangeArrowheads="1"/>
          </p:cNvSpPr>
          <p:nvPr/>
        </p:nvSpPr>
        <p:spPr bwMode="auto">
          <a:xfrm>
            <a:off x="6827838" y="2093913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52CC98"/>
                </a:solidFill>
                <a:effectLst/>
                <a:latin typeface="Adobe Devanagari" panose="02040503050201020203" pitchFamily="18" charset="0"/>
              </a:rPr>
              <a:t>66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7" name="Rectangle 124"/>
          <p:cNvSpPr>
            <a:spLocks noChangeArrowheads="1"/>
          </p:cNvSpPr>
          <p:nvPr/>
        </p:nvSpPr>
        <p:spPr bwMode="auto">
          <a:xfrm>
            <a:off x="7343776" y="4767263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7552CC"/>
                </a:solidFill>
                <a:effectLst/>
                <a:latin typeface="Adobe Devanagari" panose="02040503050201020203" pitchFamily="18" charset="0"/>
              </a:rPr>
              <a:t>96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8" name="Rectangle 125"/>
          <p:cNvSpPr>
            <a:spLocks noChangeArrowheads="1"/>
          </p:cNvSpPr>
          <p:nvPr/>
        </p:nvSpPr>
        <p:spPr bwMode="auto">
          <a:xfrm>
            <a:off x="6181726" y="3582988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CCBB52"/>
                </a:solidFill>
                <a:effectLst/>
                <a:latin typeface="Adobe Devanagari" panose="02040503050201020203" pitchFamily="18" charset="0"/>
              </a:rPr>
              <a:t>47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29" name="Rectangle 126"/>
          <p:cNvSpPr>
            <a:spLocks noChangeArrowheads="1"/>
          </p:cNvSpPr>
          <p:nvPr/>
        </p:nvSpPr>
        <p:spPr bwMode="auto">
          <a:xfrm>
            <a:off x="7264401" y="4500563"/>
            <a:ext cx="13946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CC52BB"/>
                </a:solidFill>
                <a:effectLst/>
                <a:latin typeface="Adobe Devanagari" panose="02040503050201020203" pitchFamily="18" charset="0"/>
              </a:rPr>
              <a:t>100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0" name="Rectangle 127"/>
          <p:cNvSpPr>
            <a:spLocks noChangeArrowheads="1"/>
          </p:cNvSpPr>
          <p:nvPr/>
        </p:nvSpPr>
        <p:spPr bwMode="auto">
          <a:xfrm>
            <a:off x="8612188" y="1952625"/>
            <a:ext cx="13946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CC52BB"/>
                </a:solidFill>
                <a:effectLst/>
                <a:latin typeface="Adobe Devanagari" panose="02040503050201020203" pitchFamily="18" charset="0"/>
              </a:rPr>
              <a:t>100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1" name="Rectangle 128"/>
          <p:cNvSpPr>
            <a:spLocks noChangeArrowheads="1"/>
          </p:cNvSpPr>
          <p:nvPr/>
        </p:nvSpPr>
        <p:spPr bwMode="auto">
          <a:xfrm>
            <a:off x="8443913" y="1611313"/>
            <a:ext cx="13946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CC52BB"/>
                </a:solidFill>
                <a:effectLst/>
                <a:latin typeface="Adobe Devanagari" panose="02040503050201020203" pitchFamily="18" charset="0"/>
              </a:rPr>
              <a:t>100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2" name="Rectangle 129"/>
          <p:cNvSpPr>
            <a:spLocks noChangeArrowheads="1"/>
          </p:cNvSpPr>
          <p:nvPr/>
        </p:nvSpPr>
        <p:spPr bwMode="auto">
          <a:xfrm>
            <a:off x="7802563" y="5656263"/>
            <a:ext cx="13946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CC52BB"/>
                </a:solidFill>
                <a:effectLst/>
                <a:latin typeface="Adobe Devanagari" panose="02040503050201020203" pitchFamily="18" charset="0"/>
              </a:rPr>
              <a:t>100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3" name="Rectangle 130"/>
          <p:cNvSpPr>
            <a:spLocks noChangeArrowheads="1"/>
          </p:cNvSpPr>
          <p:nvPr/>
        </p:nvSpPr>
        <p:spPr bwMode="auto">
          <a:xfrm>
            <a:off x="6719888" y="5167313"/>
            <a:ext cx="13946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CC52BB"/>
                </a:solidFill>
                <a:effectLst/>
                <a:latin typeface="Adobe Devanagari" panose="02040503050201020203" pitchFamily="18" charset="0"/>
              </a:rPr>
              <a:t>100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4" name="Rectangle 131"/>
          <p:cNvSpPr>
            <a:spLocks noChangeArrowheads="1"/>
          </p:cNvSpPr>
          <p:nvPr/>
        </p:nvSpPr>
        <p:spPr bwMode="auto">
          <a:xfrm>
            <a:off x="7366001" y="6367463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573D99"/>
                </a:solidFill>
                <a:effectLst/>
                <a:latin typeface="Adobe Devanagari" panose="02040503050201020203" pitchFamily="18" charset="0"/>
              </a:rPr>
              <a:t>99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5" name="Rectangle 132"/>
          <p:cNvSpPr>
            <a:spLocks noChangeArrowheads="1"/>
          </p:cNvSpPr>
          <p:nvPr/>
        </p:nvSpPr>
        <p:spPr bwMode="auto">
          <a:xfrm>
            <a:off x="7369176" y="4233863"/>
            <a:ext cx="13946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CC52BB"/>
                </a:solidFill>
                <a:effectLst/>
                <a:latin typeface="Adobe Devanagari" panose="02040503050201020203" pitchFamily="18" charset="0"/>
              </a:rPr>
              <a:t>100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6" name="Rectangle 133"/>
          <p:cNvSpPr>
            <a:spLocks noChangeArrowheads="1"/>
          </p:cNvSpPr>
          <p:nvPr/>
        </p:nvSpPr>
        <p:spPr bwMode="auto">
          <a:xfrm>
            <a:off x="6967538" y="676275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3D7299"/>
                </a:solidFill>
                <a:effectLst/>
                <a:latin typeface="Adobe Devanagari" panose="02040503050201020203" pitchFamily="18" charset="0"/>
              </a:rPr>
              <a:t>93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7" name="Rectangle 134"/>
          <p:cNvSpPr>
            <a:spLocks noChangeArrowheads="1"/>
          </p:cNvSpPr>
          <p:nvPr/>
        </p:nvSpPr>
        <p:spPr bwMode="auto">
          <a:xfrm>
            <a:off x="7681913" y="5478463"/>
            <a:ext cx="13946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CC52BB"/>
                </a:solidFill>
                <a:effectLst/>
                <a:latin typeface="Adobe Devanagari" panose="02040503050201020203" pitchFamily="18" charset="0"/>
              </a:rPr>
              <a:t>100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8" name="Rectangle 135"/>
          <p:cNvSpPr>
            <a:spLocks noChangeArrowheads="1"/>
          </p:cNvSpPr>
          <p:nvPr/>
        </p:nvSpPr>
        <p:spPr bwMode="auto">
          <a:xfrm>
            <a:off x="7081838" y="2574925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57993D"/>
                </a:solidFill>
                <a:effectLst/>
                <a:latin typeface="Adobe Devanagari" panose="02040503050201020203" pitchFamily="18" charset="0"/>
              </a:rPr>
              <a:t>62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39" name="Rectangle 136"/>
          <p:cNvSpPr>
            <a:spLocks noChangeArrowheads="1"/>
          </p:cNvSpPr>
          <p:nvPr/>
        </p:nvSpPr>
        <p:spPr bwMode="auto">
          <a:xfrm>
            <a:off x="6481763" y="3760788"/>
            <a:ext cx="13946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CC52BB"/>
                </a:solidFill>
                <a:effectLst/>
                <a:latin typeface="Adobe Devanagari" panose="02040503050201020203" pitchFamily="18" charset="0"/>
              </a:rPr>
              <a:t>100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0" name="Rectangle 137"/>
          <p:cNvSpPr>
            <a:spLocks noChangeArrowheads="1"/>
          </p:cNvSpPr>
          <p:nvPr/>
        </p:nvSpPr>
        <p:spPr bwMode="auto">
          <a:xfrm>
            <a:off x="7366001" y="4945063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5298CC"/>
                </a:solidFill>
                <a:effectLst/>
                <a:latin typeface="Adobe Devanagari" panose="02040503050201020203" pitchFamily="18" charset="0"/>
              </a:rPr>
              <a:t>90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1" name="Rectangle 138"/>
          <p:cNvSpPr>
            <a:spLocks noChangeArrowheads="1"/>
          </p:cNvSpPr>
          <p:nvPr/>
        </p:nvSpPr>
        <p:spPr bwMode="auto">
          <a:xfrm>
            <a:off x="8056563" y="3049588"/>
            <a:ext cx="13946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CC52BB"/>
                </a:solidFill>
                <a:effectLst/>
                <a:latin typeface="Adobe Devanagari" panose="02040503050201020203" pitchFamily="18" charset="0"/>
              </a:rPr>
              <a:t>100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2" name="Rectangle 139"/>
          <p:cNvSpPr>
            <a:spLocks noChangeArrowheads="1"/>
          </p:cNvSpPr>
          <p:nvPr/>
        </p:nvSpPr>
        <p:spPr bwMode="auto">
          <a:xfrm>
            <a:off x="8623301" y="1685925"/>
            <a:ext cx="9297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998C3D"/>
                </a:solidFill>
                <a:effectLst/>
                <a:latin typeface="Adobe Devanagari" panose="02040503050201020203" pitchFamily="18" charset="0"/>
              </a:rPr>
              <a:t>51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3" name="Rectangle 140"/>
          <p:cNvSpPr>
            <a:spLocks noChangeArrowheads="1"/>
          </p:cNvSpPr>
          <p:nvPr/>
        </p:nvSpPr>
        <p:spPr bwMode="auto">
          <a:xfrm>
            <a:off x="7318376" y="6189663"/>
            <a:ext cx="13946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CC52BB"/>
                </a:solidFill>
                <a:effectLst/>
                <a:latin typeface="Adobe Devanagari" panose="02040503050201020203" pitchFamily="18" charset="0"/>
              </a:rPr>
              <a:t>100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4" name="Rectangle 141"/>
          <p:cNvSpPr>
            <a:spLocks noChangeArrowheads="1"/>
          </p:cNvSpPr>
          <p:nvPr/>
        </p:nvSpPr>
        <p:spPr bwMode="auto">
          <a:xfrm>
            <a:off x="6754813" y="498475"/>
            <a:ext cx="13946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fr-FR" altLang="fr-FR" sz="800" b="0" i="0" u="none" strike="noStrike" cap="none" normalizeH="0" baseline="0" smtClean="0">
                <a:ln>
                  <a:noFill/>
                </a:ln>
                <a:solidFill>
                  <a:srgbClr val="CC52BB"/>
                </a:solidFill>
                <a:effectLst/>
                <a:latin typeface="Adobe Devanagari" panose="02040503050201020203" pitchFamily="18" charset="0"/>
              </a:rPr>
              <a:t>100</a:t>
            </a:r>
            <a:endParaRPr kumimoji="0" lang="fr-FR" altLang="fr-FR" sz="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  <p:sp>
        <p:nvSpPr>
          <p:cNvPr id="145" name="ZoneTexte 144"/>
          <p:cNvSpPr txBox="1"/>
          <p:nvPr/>
        </p:nvSpPr>
        <p:spPr>
          <a:xfrm>
            <a:off x="388189" y="4019551"/>
            <a:ext cx="2329132" cy="101566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FR" sz="1000" b="1" dirty="0" smtClean="0"/>
              <a:t>PIWI</a:t>
            </a:r>
          </a:p>
          <a:p>
            <a:r>
              <a:rPr lang="fr-FR" sz="1000" dirty="0" smtClean="0"/>
              <a:t>gt 0.5</a:t>
            </a:r>
          </a:p>
          <a:p>
            <a:r>
              <a:rPr lang="fr-FR" sz="1000" dirty="0" smtClean="0"/>
              <a:t>RAXML</a:t>
            </a:r>
          </a:p>
          <a:p>
            <a:r>
              <a:rPr lang="fr-FR" sz="1000" dirty="0" smtClean="0"/>
              <a:t>PROTGAMMAUTO</a:t>
            </a:r>
          </a:p>
          <a:p>
            <a:r>
              <a:rPr lang="fr-FR" sz="1000" dirty="0" smtClean="0"/>
              <a:t>500 </a:t>
            </a:r>
            <a:r>
              <a:rPr lang="fr-FR" sz="1000" dirty="0" err="1" smtClean="0"/>
              <a:t>bootstraps</a:t>
            </a:r>
            <a:endParaRPr lang="fr-FR" sz="1000" dirty="0" smtClean="0"/>
          </a:p>
          <a:p>
            <a:r>
              <a:rPr lang="fr-FR" sz="1000" dirty="0" smtClean="0"/>
              <a:t>Best model: LG</a:t>
            </a:r>
            <a:endParaRPr lang="fr-FR" sz="1000" dirty="0"/>
          </a:p>
        </p:txBody>
      </p:sp>
    </p:spTree>
    <p:extLst>
      <p:ext uri="{BB962C8B-B14F-4D97-AF65-F5344CB8AC3E}">
        <p14:creationId xmlns:p14="http://schemas.microsoft.com/office/powerpoint/2010/main" val="174680729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1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Thème1" id="{8369EA16-FC18-420F-B65D-1B55019E0363}" vid="{80D3CE8A-49F4-4B44-AEE0-29301DB73F46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2</TotalTime>
  <Words>65</Words>
  <Application>Microsoft Office PowerPoint</Application>
  <PresentationFormat>Format A4 (210 x 297 mm)</PresentationFormat>
  <Paragraphs>60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1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tienne Danchin</dc:creator>
  <cp:lastModifiedBy>zurletto</cp:lastModifiedBy>
  <cp:revision>2</cp:revision>
  <dcterms:created xsi:type="dcterms:W3CDTF">2018-02-14T12:15:38Z</dcterms:created>
  <dcterms:modified xsi:type="dcterms:W3CDTF">2018-02-28T14:42:37Z</dcterms:modified>
</cp:coreProperties>
</file>